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762" y="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8607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0738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999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781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278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412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6886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1073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022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9384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892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295A4-88AD-4D54-A649-9D83D04CDA35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7938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60EAE73-A82C-1D28-70B5-2D17BA35FE22}"/>
              </a:ext>
            </a:extLst>
          </p:cNvPr>
          <p:cNvSpPr txBox="1"/>
          <p:nvPr/>
        </p:nvSpPr>
        <p:spPr>
          <a:xfrm>
            <a:off x="149134" y="802084"/>
            <a:ext cx="16001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a) Seed tubers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C6E5B32-5720-E94C-791B-1C0C23E8715F}"/>
              </a:ext>
            </a:extLst>
          </p:cNvPr>
          <p:cNvSpPr txBox="1"/>
          <p:nvPr/>
        </p:nvSpPr>
        <p:spPr>
          <a:xfrm>
            <a:off x="149134" y="5424043"/>
            <a:ext cx="18950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b) Stem seedlings</a:t>
            </a:r>
          </a:p>
        </p:txBody>
      </p:sp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7250C67B-E8D2-3E23-9373-DF459CD0AC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3383252"/>
              </p:ext>
            </p:extLst>
          </p:nvPr>
        </p:nvGraphicFramePr>
        <p:xfrm>
          <a:off x="3379396" y="3337050"/>
          <a:ext cx="2870195" cy="714375"/>
        </p:xfrm>
        <a:graphic>
          <a:graphicData uri="http://schemas.openxmlformats.org/drawingml/2006/table">
            <a:tbl>
              <a:tblPr/>
              <a:tblGrid>
                <a:gridCol w="574039">
                  <a:extLst>
                    <a:ext uri="{9D8B030D-6E8A-4147-A177-3AD203B41FA5}">
                      <a16:colId xmlns:a16="http://schemas.microsoft.com/office/drawing/2014/main" val="446770892"/>
                    </a:ext>
                  </a:extLst>
                </a:gridCol>
                <a:gridCol w="574039">
                  <a:extLst>
                    <a:ext uri="{9D8B030D-6E8A-4147-A177-3AD203B41FA5}">
                      <a16:colId xmlns:a16="http://schemas.microsoft.com/office/drawing/2014/main" val="3795501322"/>
                    </a:ext>
                  </a:extLst>
                </a:gridCol>
                <a:gridCol w="574039">
                  <a:extLst>
                    <a:ext uri="{9D8B030D-6E8A-4147-A177-3AD203B41FA5}">
                      <a16:colId xmlns:a16="http://schemas.microsoft.com/office/drawing/2014/main" val="1155121705"/>
                    </a:ext>
                  </a:extLst>
                </a:gridCol>
                <a:gridCol w="574039">
                  <a:extLst>
                    <a:ext uri="{9D8B030D-6E8A-4147-A177-3AD203B41FA5}">
                      <a16:colId xmlns:a16="http://schemas.microsoft.com/office/drawing/2014/main" val="4211505847"/>
                    </a:ext>
                  </a:extLst>
                </a:gridCol>
                <a:gridCol w="574039">
                  <a:extLst>
                    <a:ext uri="{9D8B030D-6E8A-4147-A177-3AD203B41FA5}">
                      <a16:colId xmlns:a16="http://schemas.microsoft.com/office/drawing/2014/main" val="1961082382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z 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9367341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tercep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87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7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1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0139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9323378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/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3.52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9.06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90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1603829"/>
                  </a:ext>
                </a:extLst>
              </a:tr>
            </a:tbl>
          </a:graphicData>
        </a:graphic>
      </p:graphicFrame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66BCB837-1E4F-2225-0975-B84CCE3EBC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7737463"/>
              </p:ext>
            </p:extLst>
          </p:nvPr>
        </p:nvGraphicFramePr>
        <p:xfrm>
          <a:off x="3379396" y="8111201"/>
          <a:ext cx="2870195" cy="714375"/>
        </p:xfrm>
        <a:graphic>
          <a:graphicData uri="http://schemas.openxmlformats.org/drawingml/2006/table">
            <a:tbl>
              <a:tblPr/>
              <a:tblGrid>
                <a:gridCol w="574039">
                  <a:extLst>
                    <a:ext uri="{9D8B030D-6E8A-4147-A177-3AD203B41FA5}">
                      <a16:colId xmlns:a16="http://schemas.microsoft.com/office/drawing/2014/main" val="484266081"/>
                    </a:ext>
                  </a:extLst>
                </a:gridCol>
                <a:gridCol w="574039">
                  <a:extLst>
                    <a:ext uri="{9D8B030D-6E8A-4147-A177-3AD203B41FA5}">
                      <a16:colId xmlns:a16="http://schemas.microsoft.com/office/drawing/2014/main" val="3364615163"/>
                    </a:ext>
                  </a:extLst>
                </a:gridCol>
                <a:gridCol w="574039">
                  <a:extLst>
                    <a:ext uri="{9D8B030D-6E8A-4147-A177-3AD203B41FA5}">
                      <a16:colId xmlns:a16="http://schemas.microsoft.com/office/drawing/2014/main" val="2291583605"/>
                    </a:ext>
                  </a:extLst>
                </a:gridCol>
                <a:gridCol w="574039">
                  <a:extLst>
                    <a:ext uri="{9D8B030D-6E8A-4147-A177-3AD203B41FA5}">
                      <a16:colId xmlns:a16="http://schemas.microsoft.com/office/drawing/2014/main" val="2831573278"/>
                    </a:ext>
                  </a:extLst>
                </a:gridCol>
                <a:gridCol w="574039">
                  <a:extLst>
                    <a:ext uri="{9D8B030D-6E8A-4147-A177-3AD203B41FA5}">
                      <a16:colId xmlns:a16="http://schemas.microsoft.com/office/drawing/2014/main" val="4025534849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z 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67152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tercep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69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002484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/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52.4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99.5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3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7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1472859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1E3E29C-FDA7-17E3-02A6-E973CE8DE26E}"/>
              </a:ext>
            </a:extLst>
          </p:cNvPr>
          <p:cNvSpPr txBox="1"/>
          <p:nvPr/>
        </p:nvSpPr>
        <p:spPr>
          <a:xfrm>
            <a:off x="0" y="65907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 Figure 1.</a:t>
            </a:r>
          </a:p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obit regression results of “the detection of probability”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4">
            <a:extLst>
              <a:ext uri="{FF2B5EF4-FFF2-40B4-BE49-F238E27FC236}">
                <a16:creationId xmlns:a16="http://schemas.microsoft.com/office/drawing/2014/main" id="{4FB4F91E-DD7A-8696-3542-3E535B32167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956887" y="1268930"/>
            <a:ext cx="4610101" cy="4232276"/>
            <a:chOff x="1219" y="799"/>
            <a:chExt cx="2904" cy="2666"/>
          </a:xfrm>
        </p:grpSpPr>
        <p:sp>
          <p:nvSpPr>
            <p:cNvPr id="10" name="Rectangle 5">
              <a:extLst>
                <a:ext uri="{FF2B5EF4-FFF2-40B4-BE49-F238E27FC236}">
                  <a16:creationId xmlns:a16="http://schemas.microsoft.com/office/drawing/2014/main" id="{98C023CE-051A-ABB4-BCCF-4CD970A6E9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7" y="873"/>
              <a:ext cx="14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Rectangle 6">
              <a:extLst>
                <a:ext uri="{FF2B5EF4-FFF2-40B4-BE49-F238E27FC236}">
                  <a16:creationId xmlns:a16="http://schemas.microsoft.com/office/drawing/2014/main" id="{23D72C24-745D-DED1-1766-04EB7CED3D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7" y="900"/>
              <a:ext cx="14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Rectangle 7">
              <a:extLst>
                <a:ext uri="{FF2B5EF4-FFF2-40B4-BE49-F238E27FC236}">
                  <a16:creationId xmlns:a16="http://schemas.microsoft.com/office/drawing/2014/main" id="{8E1F9AE3-47EE-18D9-2FB6-5C009EB959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2" y="877"/>
              <a:ext cx="2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Rectangle 8">
              <a:extLst>
                <a:ext uri="{FF2B5EF4-FFF2-40B4-BE49-F238E27FC236}">
                  <a16:creationId xmlns:a16="http://schemas.microsoft.com/office/drawing/2014/main" id="{EFE65E80-0FA7-C503-7861-3D4EAF60C9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2" y="896"/>
              <a:ext cx="2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Rectangle 9">
              <a:extLst>
                <a:ext uri="{FF2B5EF4-FFF2-40B4-BE49-F238E27FC236}">
                  <a16:creationId xmlns:a16="http://schemas.microsoft.com/office/drawing/2014/main" id="{2DD6EF52-EC94-E326-B336-746A697471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8" y="882"/>
              <a:ext cx="32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Rectangle 10">
              <a:extLst>
                <a:ext uri="{FF2B5EF4-FFF2-40B4-BE49-F238E27FC236}">
                  <a16:creationId xmlns:a16="http://schemas.microsoft.com/office/drawing/2014/main" id="{F66E4ACE-5D69-1455-3B73-2FEE049409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8" y="891"/>
              <a:ext cx="32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Rectangle 11">
              <a:extLst>
                <a:ext uri="{FF2B5EF4-FFF2-40B4-BE49-F238E27FC236}">
                  <a16:creationId xmlns:a16="http://schemas.microsoft.com/office/drawing/2014/main" id="{FF9040F4-6840-FAB9-6BD1-824C9C88DB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8" y="887"/>
              <a:ext cx="3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Rectangle 12">
              <a:extLst>
                <a:ext uri="{FF2B5EF4-FFF2-40B4-BE49-F238E27FC236}">
                  <a16:creationId xmlns:a16="http://schemas.microsoft.com/office/drawing/2014/main" id="{E4FAB4C7-62F6-6034-33F4-9ACABA8C51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8" y="887"/>
              <a:ext cx="3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Oval 13">
              <a:extLst>
                <a:ext uri="{FF2B5EF4-FFF2-40B4-BE49-F238E27FC236}">
                  <a16:creationId xmlns:a16="http://schemas.microsoft.com/office/drawing/2014/main" id="{94175DF2-D2C0-DC3F-2957-36A49B1138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8" y="873"/>
              <a:ext cx="27" cy="27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Rectangle 14">
              <a:extLst>
                <a:ext uri="{FF2B5EF4-FFF2-40B4-BE49-F238E27FC236}">
                  <a16:creationId xmlns:a16="http://schemas.microsoft.com/office/drawing/2014/main" id="{7001355D-9C29-18FB-5745-D46FED2A78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1" y="1222"/>
              <a:ext cx="1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" name="Rectangle 15">
              <a:extLst>
                <a:ext uri="{FF2B5EF4-FFF2-40B4-BE49-F238E27FC236}">
                  <a16:creationId xmlns:a16="http://schemas.microsoft.com/office/drawing/2014/main" id="{D6A11254-5EA7-6E9F-FB10-EDBF23A383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1" y="1249"/>
              <a:ext cx="1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Rectangle 16">
              <a:extLst>
                <a:ext uri="{FF2B5EF4-FFF2-40B4-BE49-F238E27FC236}">
                  <a16:creationId xmlns:a16="http://schemas.microsoft.com/office/drawing/2014/main" id="{3722B352-9258-2FC9-6936-0B5E2A4B84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6" y="1226"/>
              <a:ext cx="2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Rectangle 17">
              <a:extLst>
                <a:ext uri="{FF2B5EF4-FFF2-40B4-BE49-F238E27FC236}">
                  <a16:creationId xmlns:a16="http://schemas.microsoft.com/office/drawing/2014/main" id="{EF602146-7CAC-2433-2339-8AD069C944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6" y="1245"/>
              <a:ext cx="2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Rectangle 18">
              <a:extLst>
                <a:ext uri="{FF2B5EF4-FFF2-40B4-BE49-F238E27FC236}">
                  <a16:creationId xmlns:a16="http://schemas.microsoft.com/office/drawing/2014/main" id="{84911CB8-0393-9154-FD8B-D745A7C71D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1" y="1231"/>
              <a:ext cx="3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Rectangle 19">
              <a:extLst>
                <a:ext uri="{FF2B5EF4-FFF2-40B4-BE49-F238E27FC236}">
                  <a16:creationId xmlns:a16="http://schemas.microsoft.com/office/drawing/2014/main" id="{18CE47D7-3762-6EAB-3879-EC59B8E5D6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1" y="1240"/>
              <a:ext cx="3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Rectangle 20">
              <a:extLst>
                <a:ext uri="{FF2B5EF4-FFF2-40B4-BE49-F238E27FC236}">
                  <a16:creationId xmlns:a16="http://schemas.microsoft.com/office/drawing/2014/main" id="{9E5D7A11-D4DA-A4FE-9951-17C114FB7C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1" y="1236"/>
              <a:ext cx="3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Rectangle 21">
              <a:extLst>
                <a:ext uri="{FF2B5EF4-FFF2-40B4-BE49-F238E27FC236}">
                  <a16:creationId xmlns:a16="http://schemas.microsoft.com/office/drawing/2014/main" id="{C8CF397B-7A44-40E5-C564-375B399C2D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1" y="1236"/>
              <a:ext cx="3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Oval 22">
              <a:extLst>
                <a:ext uri="{FF2B5EF4-FFF2-40B4-BE49-F238E27FC236}">
                  <a16:creationId xmlns:a16="http://schemas.microsoft.com/office/drawing/2014/main" id="{0A95B14C-7674-32F2-BB6B-CBEAAE9721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1" y="1222"/>
              <a:ext cx="28" cy="27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Rectangle 23">
              <a:extLst>
                <a:ext uri="{FF2B5EF4-FFF2-40B4-BE49-F238E27FC236}">
                  <a16:creationId xmlns:a16="http://schemas.microsoft.com/office/drawing/2014/main" id="{DF47464E-594E-ADE0-3CA4-6D98362D9A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7" y="1222"/>
              <a:ext cx="14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Rectangle 24">
              <a:extLst>
                <a:ext uri="{FF2B5EF4-FFF2-40B4-BE49-F238E27FC236}">
                  <a16:creationId xmlns:a16="http://schemas.microsoft.com/office/drawing/2014/main" id="{1D34AA35-80E9-C98F-99DE-AB0798F6A5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7" y="1249"/>
              <a:ext cx="14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Rectangle 25">
              <a:extLst>
                <a:ext uri="{FF2B5EF4-FFF2-40B4-BE49-F238E27FC236}">
                  <a16:creationId xmlns:a16="http://schemas.microsoft.com/office/drawing/2014/main" id="{172B14C2-3D19-733C-C2C7-8D1CEE7B1E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3" y="1226"/>
              <a:ext cx="2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" name="Rectangle 26">
              <a:extLst>
                <a:ext uri="{FF2B5EF4-FFF2-40B4-BE49-F238E27FC236}">
                  <a16:creationId xmlns:a16="http://schemas.microsoft.com/office/drawing/2014/main" id="{E7B1E597-0C51-F28C-8B53-C4B46A78F8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3" y="1245"/>
              <a:ext cx="2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" name="Rectangle 27">
              <a:extLst>
                <a:ext uri="{FF2B5EF4-FFF2-40B4-BE49-F238E27FC236}">
                  <a16:creationId xmlns:a16="http://schemas.microsoft.com/office/drawing/2014/main" id="{7F784E89-A5D7-1588-949D-5ABF7E1946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1231"/>
              <a:ext cx="32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" name="Rectangle 28">
              <a:extLst>
                <a:ext uri="{FF2B5EF4-FFF2-40B4-BE49-F238E27FC236}">
                  <a16:creationId xmlns:a16="http://schemas.microsoft.com/office/drawing/2014/main" id="{396169D0-2B03-0F71-336B-6ABCBEE9E4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1240"/>
              <a:ext cx="32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" name="Rectangle 29">
              <a:extLst>
                <a:ext uri="{FF2B5EF4-FFF2-40B4-BE49-F238E27FC236}">
                  <a16:creationId xmlns:a16="http://schemas.microsoft.com/office/drawing/2014/main" id="{C60752A1-1556-FDB3-34EA-CE02EEC1C0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1236"/>
              <a:ext cx="3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" name="Rectangle 30">
              <a:extLst>
                <a:ext uri="{FF2B5EF4-FFF2-40B4-BE49-F238E27FC236}">
                  <a16:creationId xmlns:a16="http://schemas.microsoft.com/office/drawing/2014/main" id="{66FCC50C-93F9-2D35-DBAE-E6DD24AE0A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1236"/>
              <a:ext cx="3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Oval 31">
              <a:extLst>
                <a:ext uri="{FF2B5EF4-FFF2-40B4-BE49-F238E27FC236}">
                  <a16:creationId xmlns:a16="http://schemas.microsoft.com/office/drawing/2014/main" id="{32E4D3FF-208C-1A77-F4A8-842201C21E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8" y="1222"/>
              <a:ext cx="28" cy="27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Rectangle 32">
              <a:extLst>
                <a:ext uri="{FF2B5EF4-FFF2-40B4-BE49-F238E27FC236}">
                  <a16:creationId xmlns:a16="http://schemas.microsoft.com/office/drawing/2014/main" id="{E32E6D9D-B3F7-EAB9-9BA7-C82ADA13BB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2" y="1254"/>
              <a:ext cx="1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Rectangle 33">
              <a:extLst>
                <a:ext uri="{FF2B5EF4-FFF2-40B4-BE49-F238E27FC236}">
                  <a16:creationId xmlns:a16="http://schemas.microsoft.com/office/drawing/2014/main" id="{BB85A8D3-AFD9-3957-1A28-A53EBB7816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2" y="1282"/>
              <a:ext cx="1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Rectangle 34">
              <a:extLst>
                <a:ext uri="{FF2B5EF4-FFF2-40B4-BE49-F238E27FC236}">
                  <a16:creationId xmlns:a16="http://schemas.microsoft.com/office/drawing/2014/main" id="{0D843F4E-4506-8D40-E4F5-D9BAAC4863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7" y="1259"/>
              <a:ext cx="2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Rectangle 35">
              <a:extLst>
                <a:ext uri="{FF2B5EF4-FFF2-40B4-BE49-F238E27FC236}">
                  <a16:creationId xmlns:a16="http://schemas.microsoft.com/office/drawing/2014/main" id="{4E52E775-C819-8E62-15B2-77CBBB71D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7" y="1277"/>
              <a:ext cx="2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Rectangle 36">
              <a:extLst>
                <a:ext uri="{FF2B5EF4-FFF2-40B4-BE49-F238E27FC236}">
                  <a16:creationId xmlns:a16="http://schemas.microsoft.com/office/drawing/2014/main" id="{BAB282CD-84CA-93CF-4F29-29E53C3A65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2" y="1263"/>
              <a:ext cx="3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Rectangle 37">
              <a:extLst>
                <a:ext uri="{FF2B5EF4-FFF2-40B4-BE49-F238E27FC236}">
                  <a16:creationId xmlns:a16="http://schemas.microsoft.com/office/drawing/2014/main" id="{A46C7DAA-D0FB-A8E6-52F9-59A2F65F17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2" y="1272"/>
              <a:ext cx="3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Rectangle 38">
              <a:extLst>
                <a:ext uri="{FF2B5EF4-FFF2-40B4-BE49-F238E27FC236}">
                  <a16:creationId xmlns:a16="http://schemas.microsoft.com/office/drawing/2014/main" id="{5940C8DE-03F2-016F-5961-A0F44F1FA3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2" y="1268"/>
              <a:ext cx="3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Rectangle 39">
              <a:extLst>
                <a:ext uri="{FF2B5EF4-FFF2-40B4-BE49-F238E27FC236}">
                  <a16:creationId xmlns:a16="http://schemas.microsoft.com/office/drawing/2014/main" id="{26E8B2A3-BBC2-E9E5-C483-441FC7992B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2" y="1268"/>
              <a:ext cx="3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Oval 40">
              <a:extLst>
                <a:ext uri="{FF2B5EF4-FFF2-40B4-BE49-F238E27FC236}">
                  <a16:creationId xmlns:a16="http://schemas.microsoft.com/office/drawing/2014/main" id="{4B4F61E9-F73B-36CE-36B9-9ADEBB02D9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2" y="1254"/>
              <a:ext cx="28" cy="2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Rectangle 41">
              <a:extLst>
                <a:ext uri="{FF2B5EF4-FFF2-40B4-BE49-F238E27FC236}">
                  <a16:creationId xmlns:a16="http://schemas.microsoft.com/office/drawing/2014/main" id="{BECD2E7B-9809-A285-3951-2AF7F151C8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6" y="1268"/>
              <a:ext cx="14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Rectangle 42">
              <a:extLst>
                <a:ext uri="{FF2B5EF4-FFF2-40B4-BE49-F238E27FC236}">
                  <a16:creationId xmlns:a16="http://schemas.microsoft.com/office/drawing/2014/main" id="{CBBA2538-F15C-EA17-7592-A8F74EB7F4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6" y="1295"/>
              <a:ext cx="14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Rectangle 43">
              <a:extLst>
                <a:ext uri="{FF2B5EF4-FFF2-40B4-BE49-F238E27FC236}">
                  <a16:creationId xmlns:a16="http://schemas.microsoft.com/office/drawing/2014/main" id="{A2B3222C-1EF8-A8EC-FF81-45982F9AB3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1" y="1272"/>
              <a:ext cx="2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Rectangle 44">
              <a:extLst>
                <a:ext uri="{FF2B5EF4-FFF2-40B4-BE49-F238E27FC236}">
                  <a16:creationId xmlns:a16="http://schemas.microsoft.com/office/drawing/2014/main" id="{48DB8423-ABEE-6AF0-E988-6A8E414D29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1" y="1291"/>
              <a:ext cx="2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Rectangle 45">
              <a:extLst>
                <a:ext uri="{FF2B5EF4-FFF2-40B4-BE49-F238E27FC236}">
                  <a16:creationId xmlns:a16="http://schemas.microsoft.com/office/drawing/2014/main" id="{52FDB4A8-0500-E1F0-5025-0919FF9BE6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7" y="1277"/>
              <a:ext cx="32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Rectangle 46">
              <a:extLst>
                <a:ext uri="{FF2B5EF4-FFF2-40B4-BE49-F238E27FC236}">
                  <a16:creationId xmlns:a16="http://schemas.microsoft.com/office/drawing/2014/main" id="{76FC3BE4-0779-A47D-E5E6-7E732E8064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7" y="1286"/>
              <a:ext cx="32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Rectangle 47">
              <a:extLst>
                <a:ext uri="{FF2B5EF4-FFF2-40B4-BE49-F238E27FC236}">
                  <a16:creationId xmlns:a16="http://schemas.microsoft.com/office/drawing/2014/main" id="{B57CD73B-B170-152F-8D6A-7515EC6A95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7" y="1282"/>
              <a:ext cx="3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Rectangle 48">
              <a:extLst>
                <a:ext uri="{FF2B5EF4-FFF2-40B4-BE49-F238E27FC236}">
                  <a16:creationId xmlns:a16="http://schemas.microsoft.com/office/drawing/2014/main" id="{E7874E33-BB6F-2081-FDC8-626BD2EC1C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7" y="1282"/>
              <a:ext cx="3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Oval 49">
              <a:extLst>
                <a:ext uri="{FF2B5EF4-FFF2-40B4-BE49-F238E27FC236}">
                  <a16:creationId xmlns:a16="http://schemas.microsoft.com/office/drawing/2014/main" id="{5E235D07-B0E2-8585-3EA3-543F32052E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7" y="1268"/>
              <a:ext cx="27" cy="27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Rectangle 50">
              <a:extLst>
                <a:ext uri="{FF2B5EF4-FFF2-40B4-BE49-F238E27FC236}">
                  <a16:creationId xmlns:a16="http://schemas.microsoft.com/office/drawing/2014/main" id="{96BB309B-6C50-45E1-5941-540462B9BA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2" y="873"/>
              <a:ext cx="1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Rectangle 51">
              <a:extLst>
                <a:ext uri="{FF2B5EF4-FFF2-40B4-BE49-F238E27FC236}">
                  <a16:creationId xmlns:a16="http://schemas.microsoft.com/office/drawing/2014/main" id="{4E4F4C5C-93C8-DDD2-532B-27C7534B1B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2" y="900"/>
              <a:ext cx="1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Rectangle 52">
              <a:extLst>
                <a:ext uri="{FF2B5EF4-FFF2-40B4-BE49-F238E27FC236}">
                  <a16:creationId xmlns:a16="http://schemas.microsoft.com/office/drawing/2014/main" id="{489AB8A0-88AB-278B-D746-BC94CDEF33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7" y="877"/>
              <a:ext cx="2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Rectangle 53">
              <a:extLst>
                <a:ext uri="{FF2B5EF4-FFF2-40B4-BE49-F238E27FC236}">
                  <a16:creationId xmlns:a16="http://schemas.microsoft.com/office/drawing/2014/main" id="{7FEC2B67-B4A2-5CA8-A931-D6658EF5B4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7" y="896"/>
              <a:ext cx="2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Rectangle 54">
              <a:extLst>
                <a:ext uri="{FF2B5EF4-FFF2-40B4-BE49-F238E27FC236}">
                  <a16:creationId xmlns:a16="http://schemas.microsoft.com/office/drawing/2014/main" id="{B9EAAE64-F4A4-3DDB-29CD-5B99FB4112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2" y="882"/>
              <a:ext cx="3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Rectangle 55">
              <a:extLst>
                <a:ext uri="{FF2B5EF4-FFF2-40B4-BE49-F238E27FC236}">
                  <a16:creationId xmlns:a16="http://schemas.microsoft.com/office/drawing/2014/main" id="{0A20D58D-AD22-CB60-7928-E832700031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2" y="891"/>
              <a:ext cx="3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Rectangle 56">
              <a:extLst>
                <a:ext uri="{FF2B5EF4-FFF2-40B4-BE49-F238E27FC236}">
                  <a16:creationId xmlns:a16="http://schemas.microsoft.com/office/drawing/2014/main" id="{9CE796C9-31AE-0A01-32AC-B2C64F141F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2" y="887"/>
              <a:ext cx="3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Rectangle 57">
              <a:extLst>
                <a:ext uri="{FF2B5EF4-FFF2-40B4-BE49-F238E27FC236}">
                  <a16:creationId xmlns:a16="http://schemas.microsoft.com/office/drawing/2014/main" id="{DC1521F7-7F18-73F3-5B22-885D8E0BC2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2" y="887"/>
              <a:ext cx="3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Oval 58">
              <a:extLst>
                <a:ext uri="{FF2B5EF4-FFF2-40B4-BE49-F238E27FC236}">
                  <a16:creationId xmlns:a16="http://schemas.microsoft.com/office/drawing/2014/main" id="{7B90153E-1216-7DEA-F552-D31E673D40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2" y="873"/>
              <a:ext cx="28" cy="27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Rectangle 59">
              <a:extLst>
                <a:ext uri="{FF2B5EF4-FFF2-40B4-BE49-F238E27FC236}">
                  <a16:creationId xmlns:a16="http://schemas.microsoft.com/office/drawing/2014/main" id="{C5321A21-134E-E32C-381C-808B1549FA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" y="1171"/>
              <a:ext cx="14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" name="Rectangle 60">
              <a:extLst>
                <a:ext uri="{FF2B5EF4-FFF2-40B4-BE49-F238E27FC236}">
                  <a16:creationId xmlns:a16="http://schemas.microsoft.com/office/drawing/2014/main" id="{5FDF46E1-DAC0-9478-D5AE-66C6793ABD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" y="1199"/>
              <a:ext cx="14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Rectangle 61">
              <a:extLst>
                <a:ext uri="{FF2B5EF4-FFF2-40B4-BE49-F238E27FC236}">
                  <a16:creationId xmlns:a16="http://schemas.microsoft.com/office/drawing/2014/main" id="{2AECF019-AA26-7A22-0434-D8FBA388A6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6" y="1176"/>
              <a:ext cx="2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Rectangle 62">
              <a:extLst>
                <a:ext uri="{FF2B5EF4-FFF2-40B4-BE49-F238E27FC236}">
                  <a16:creationId xmlns:a16="http://schemas.microsoft.com/office/drawing/2014/main" id="{98E3E76B-3123-4681-4B8A-CE3B470EE0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6" y="1194"/>
              <a:ext cx="2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Rectangle 63">
              <a:extLst>
                <a:ext uri="{FF2B5EF4-FFF2-40B4-BE49-F238E27FC236}">
                  <a16:creationId xmlns:a16="http://schemas.microsoft.com/office/drawing/2014/main" id="{920D7E0B-E95D-6C01-80CE-828F6474DF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1" y="1181"/>
              <a:ext cx="3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Rectangle 64">
              <a:extLst>
                <a:ext uri="{FF2B5EF4-FFF2-40B4-BE49-F238E27FC236}">
                  <a16:creationId xmlns:a16="http://schemas.microsoft.com/office/drawing/2014/main" id="{65C468AA-977D-4269-A534-1F367E232A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1" y="1190"/>
              <a:ext cx="3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Rectangle 65">
              <a:extLst>
                <a:ext uri="{FF2B5EF4-FFF2-40B4-BE49-F238E27FC236}">
                  <a16:creationId xmlns:a16="http://schemas.microsoft.com/office/drawing/2014/main" id="{E2E84F9B-D685-70A4-04B1-CD2205288A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1" y="1185"/>
              <a:ext cx="32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Rectangle 66">
              <a:extLst>
                <a:ext uri="{FF2B5EF4-FFF2-40B4-BE49-F238E27FC236}">
                  <a16:creationId xmlns:a16="http://schemas.microsoft.com/office/drawing/2014/main" id="{2518DD15-BB7C-399C-639C-21D92EEF7D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1" y="1185"/>
              <a:ext cx="32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Oval 67">
              <a:extLst>
                <a:ext uri="{FF2B5EF4-FFF2-40B4-BE49-F238E27FC236}">
                  <a16:creationId xmlns:a16="http://schemas.microsoft.com/office/drawing/2014/main" id="{F411E893-DE2B-8C87-F19E-9893F97624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1" y="1171"/>
              <a:ext cx="28" cy="28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" name="Line 68">
              <a:extLst>
                <a:ext uri="{FF2B5EF4-FFF2-40B4-BE49-F238E27FC236}">
                  <a16:creationId xmlns:a16="http://schemas.microsoft.com/office/drawing/2014/main" id="{79B44BF5-BCD3-5321-64C1-0C316D284A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73" y="3082"/>
              <a:ext cx="205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Line 69">
              <a:extLst>
                <a:ext uri="{FF2B5EF4-FFF2-40B4-BE49-F238E27FC236}">
                  <a16:creationId xmlns:a16="http://schemas.microsoft.com/office/drawing/2014/main" id="{7AFBC05F-1EAE-FF63-114B-4068E3273F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73" y="3082"/>
              <a:ext cx="0" cy="4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" name="Line 70">
              <a:extLst>
                <a:ext uri="{FF2B5EF4-FFF2-40B4-BE49-F238E27FC236}">
                  <a16:creationId xmlns:a16="http://schemas.microsoft.com/office/drawing/2014/main" id="{7F8030DF-EF68-43A1-A021-136DA9708C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8" y="3082"/>
              <a:ext cx="0" cy="4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" name="Line 71">
              <a:extLst>
                <a:ext uri="{FF2B5EF4-FFF2-40B4-BE49-F238E27FC236}">
                  <a16:creationId xmlns:a16="http://schemas.microsoft.com/office/drawing/2014/main" id="{6DA52D76-8925-F181-21DD-4BBBFB4D62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02" y="3082"/>
              <a:ext cx="0" cy="4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" name="Line 72">
              <a:extLst>
                <a:ext uri="{FF2B5EF4-FFF2-40B4-BE49-F238E27FC236}">
                  <a16:creationId xmlns:a16="http://schemas.microsoft.com/office/drawing/2014/main" id="{95DD643E-042F-F0DA-D695-5B1221E3C5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17" y="3082"/>
              <a:ext cx="0" cy="4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Line 73">
              <a:extLst>
                <a:ext uri="{FF2B5EF4-FFF2-40B4-BE49-F238E27FC236}">
                  <a16:creationId xmlns:a16="http://schemas.microsoft.com/office/drawing/2014/main" id="{6695583A-A4A2-EF2F-1F82-70C83414B8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31" y="3082"/>
              <a:ext cx="0" cy="4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1" name="Rectangle 74">
              <a:extLst>
                <a:ext uri="{FF2B5EF4-FFF2-40B4-BE49-F238E27FC236}">
                  <a16:creationId xmlns:a16="http://schemas.microsoft.com/office/drawing/2014/main" id="{7DBC6EC8-A08E-3F9F-CDB1-A3AFC4B859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1" y="3179"/>
              <a:ext cx="20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2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75">
              <a:extLst>
                <a:ext uri="{FF2B5EF4-FFF2-40B4-BE49-F238E27FC236}">
                  <a16:creationId xmlns:a16="http://schemas.microsoft.com/office/drawing/2014/main" id="{41FB79EF-1010-2694-A0A6-65DBB63547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6" y="3179"/>
              <a:ext cx="20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4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76">
              <a:extLst>
                <a:ext uri="{FF2B5EF4-FFF2-40B4-BE49-F238E27FC236}">
                  <a16:creationId xmlns:a16="http://schemas.microsoft.com/office/drawing/2014/main" id="{D6BF931A-0175-73B5-8113-D99C965DE8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0" y="3179"/>
              <a:ext cx="20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6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77">
              <a:extLst>
                <a:ext uri="{FF2B5EF4-FFF2-40B4-BE49-F238E27FC236}">
                  <a16:creationId xmlns:a16="http://schemas.microsoft.com/office/drawing/2014/main" id="{47C4C0B6-8573-99FD-9C19-342DBFE3E2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5" y="3179"/>
              <a:ext cx="20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8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78">
              <a:extLst>
                <a:ext uri="{FF2B5EF4-FFF2-40B4-BE49-F238E27FC236}">
                  <a16:creationId xmlns:a16="http://schemas.microsoft.com/office/drawing/2014/main" id="{8DF4DE53-5AC9-6925-A99A-E315E770BC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9" y="3179"/>
              <a:ext cx="20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10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Line 79">
              <a:extLst>
                <a:ext uri="{FF2B5EF4-FFF2-40B4-BE49-F238E27FC236}">
                  <a16:creationId xmlns:a16="http://schemas.microsoft.com/office/drawing/2014/main" id="{2C8469C9-8977-446A-EAF9-281279D3B1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78" y="887"/>
              <a:ext cx="0" cy="210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" name="Line 80">
              <a:extLst>
                <a:ext uri="{FF2B5EF4-FFF2-40B4-BE49-F238E27FC236}">
                  <a16:creationId xmlns:a16="http://schemas.microsoft.com/office/drawing/2014/main" id="{0FC9A6D6-7C4C-EA82-F6BE-9A3534CEB6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37" y="2995"/>
              <a:ext cx="4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" name="Line 81">
              <a:extLst>
                <a:ext uri="{FF2B5EF4-FFF2-40B4-BE49-F238E27FC236}">
                  <a16:creationId xmlns:a16="http://schemas.microsoft.com/office/drawing/2014/main" id="{7A1EC7EA-3352-F11C-0FC0-51370EB95F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37" y="2572"/>
              <a:ext cx="4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" name="Line 82">
              <a:extLst>
                <a:ext uri="{FF2B5EF4-FFF2-40B4-BE49-F238E27FC236}">
                  <a16:creationId xmlns:a16="http://schemas.microsoft.com/office/drawing/2014/main" id="{2ABB765F-8ECB-F79D-E29A-2E521A14C8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37" y="2150"/>
              <a:ext cx="4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" name="Line 83">
              <a:extLst>
                <a:ext uri="{FF2B5EF4-FFF2-40B4-BE49-F238E27FC236}">
                  <a16:creationId xmlns:a16="http://schemas.microsoft.com/office/drawing/2014/main" id="{49ED5DCF-605F-BEF6-9C71-85D3D89754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37" y="1727"/>
              <a:ext cx="4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Line 84">
              <a:extLst>
                <a:ext uri="{FF2B5EF4-FFF2-40B4-BE49-F238E27FC236}">
                  <a16:creationId xmlns:a16="http://schemas.microsoft.com/office/drawing/2014/main" id="{1E9A985B-94C3-9DC7-862B-DBA9BB32E1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37" y="1309"/>
              <a:ext cx="4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Line 85">
              <a:extLst>
                <a:ext uri="{FF2B5EF4-FFF2-40B4-BE49-F238E27FC236}">
                  <a16:creationId xmlns:a16="http://schemas.microsoft.com/office/drawing/2014/main" id="{51C0F202-680E-BF09-D71A-8F4F4AE01E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37" y="887"/>
              <a:ext cx="4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Rectangle 86">
              <a:extLst>
                <a:ext uri="{FF2B5EF4-FFF2-40B4-BE49-F238E27FC236}">
                  <a16:creationId xmlns:a16="http://schemas.microsoft.com/office/drawing/2014/main" id="{3DEC578E-4062-32EF-D82B-066D59615F9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05" y="2941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87">
              <a:extLst>
                <a:ext uri="{FF2B5EF4-FFF2-40B4-BE49-F238E27FC236}">
                  <a16:creationId xmlns:a16="http://schemas.microsoft.com/office/drawing/2014/main" id="{70E5219B-EE88-3774-EF94-65E008C8EFC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05" y="2519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88">
              <a:extLst>
                <a:ext uri="{FF2B5EF4-FFF2-40B4-BE49-F238E27FC236}">
                  <a16:creationId xmlns:a16="http://schemas.microsoft.com/office/drawing/2014/main" id="{52BBFD0D-C8B1-8D79-E9E3-CA9D91E3C88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05" y="2097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89">
              <a:extLst>
                <a:ext uri="{FF2B5EF4-FFF2-40B4-BE49-F238E27FC236}">
                  <a16:creationId xmlns:a16="http://schemas.microsoft.com/office/drawing/2014/main" id="{162A59F7-C1E7-5B27-297D-5DE9762267E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05" y="1673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90">
              <a:extLst>
                <a:ext uri="{FF2B5EF4-FFF2-40B4-BE49-F238E27FC236}">
                  <a16:creationId xmlns:a16="http://schemas.microsoft.com/office/drawing/2014/main" id="{828ECA2C-74F1-AC37-0E2B-09FEB430603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05" y="1255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91">
              <a:extLst>
                <a:ext uri="{FF2B5EF4-FFF2-40B4-BE49-F238E27FC236}">
                  <a16:creationId xmlns:a16="http://schemas.microsoft.com/office/drawing/2014/main" id="{705F8D87-DA8A-55D3-F934-BBE9B34F9D8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05" y="833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92">
              <a:extLst>
                <a:ext uri="{FF2B5EF4-FFF2-40B4-BE49-F238E27FC236}">
                  <a16:creationId xmlns:a16="http://schemas.microsoft.com/office/drawing/2014/main" id="{870DF23F-3CC6-CC4F-B235-4737B693AE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8" y="799"/>
              <a:ext cx="2545" cy="228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Rectangle 94">
              <a:extLst>
                <a:ext uri="{FF2B5EF4-FFF2-40B4-BE49-F238E27FC236}">
                  <a16:creationId xmlns:a16="http://schemas.microsoft.com/office/drawing/2014/main" id="{350F5439-444D-E764-83CF-BD85F65008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1" y="3358"/>
              <a:ext cx="13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/m</a:t>
              </a:r>
              <a:endParaRPr kumimoji="0" lang="ja-JP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Rectangle 95">
              <a:extLst>
                <a:ext uri="{FF2B5EF4-FFF2-40B4-BE49-F238E27FC236}">
                  <a16:creationId xmlns:a16="http://schemas.microsoft.com/office/drawing/2014/main" id="{DAECB4E6-6FAB-2850-1A14-E02F52074E3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761" y="1870"/>
              <a:ext cx="1052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portion Responding</a:t>
              </a:r>
              <a:endParaRPr kumimoji="0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Freeform 96">
              <a:extLst>
                <a:ext uri="{FF2B5EF4-FFF2-40B4-BE49-F238E27FC236}">
                  <a16:creationId xmlns:a16="http://schemas.microsoft.com/office/drawing/2014/main" id="{691B8182-8C10-D85F-32B6-4998F2161D7C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5" y="978"/>
              <a:ext cx="2356" cy="271"/>
            </a:xfrm>
            <a:custGeom>
              <a:avLst/>
              <a:gdLst>
                <a:gd name="T0" fmla="*/ 5 w 513"/>
                <a:gd name="T1" fmla="*/ 58 h 59"/>
                <a:gd name="T2" fmla="*/ 15 w 513"/>
                <a:gd name="T3" fmla="*/ 56 h 59"/>
                <a:gd name="T4" fmla="*/ 26 w 513"/>
                <a:gd name="T5" fmla="*/ 55 h 59"/>
                <a:gd name="T6" fmla="*/ 36 w 513"/>
                <a:gd name="T7" fmla="*/ 53 h 59"/>
                <a:gd name="T8" fmla="*/ 46 w 513"/>
                <a:gd name="T9" fmla="*/ 51 h 59"/>
                <a:gd name="T10" fmla="*/ 57 w 513"/>
                <a:gd name="T11" fmla="*/ 50 h 59"/>
                <a:gd name="T12" fmla="*/ 67 w 513"/>
                <a:gd name="T13" fmla="*/ 48 h 59"/>
                <a:gd name="T14" fmla="*/ 77 w 513"/>
                <a:gd name="T15" fmla="*/ 46 h 59"/>
                <a:gd name="T16" fmla="*/ 88 w 513"/>
                <a:gd name="T17" fmla="*/ 45 h 59"/>
                <a:gd name="T18" fmla="*/ 98 w 513"/>
                <a:gd name="T19" fmla="*/ 43 h 59"/>
                <a:gd name="T20" fmla="*/ 109 w 513"/>
                <a:gd name="T21" fmla="*/ 42 h 59"/>
                <a:gd name="T22" fmla="*/ 119 w 513"/>
                <a:gd name="T23" fmla="*/ 40 h 59"/>
                <a:gd name="T24" fmla="*/ 129 w 513"/>
                <a:gd name="T25" fmla="*/ 38 h 59"/>
                <a:gd name="T26" fmla="*/ 140 w 513"/>
                <a:gd name="T27" fmla="*/ 37 h 59"/>
                <a:gd name="T28" fmla="*/ 150 w 513"/>
                <a:gd name="T29" fmla="*/ 36 h 59"/>
                <a:gd name="T30" fmla="*/ 160 w 513"/>
                <a:gd name="T31" fmla="*/ 34 h 59"/>
                <a:gd name="T32" fmla="*/ 171 w 513"/>
                <a:gd name="T33" fmla="*/ 33 h 59"/>
                <a:gd name="T34" fmla="*/ 181 w 513"/>
                <a:gd name="T35" fmla="*/ 31 h 59"/>
                <a:gd name="T36" fmla="*/ 191 w 513"/>
                <a:gd name="T37" fmla="*/ 30 h 59"/>
                <a:gd name="T38" fmla="*/ 202 w 513"/>
                <a:gd name="T39" fmla="*/ 29 h 59"/>
                <a:gd name="T40" fmla="*/ 212 w 513"/>
                <a:gd name="T41" fmla="*/ 27 h 59"/>
                <a:gd name="T42" fmla="*/ 223 w 513"/>
                <a:gd name="T43" fmla="*/ 26 h 59"/>
                <a:gd name="T44" fmla="*/ 233 w 513"/>
                <a:gd name="T45" fmla="*/ 25 h 59"/>
                <a:gd name="T46" fmla="*/ 243 w 513"/>
                <a:gd name="T47" fmla="*/ 24 h 59"/>
                <a:gd name="T48" fmla="*/ 254 w 513"/>
                <a:gd name="T49" fmla="*/ 22 h 59"/>
                <a:gd name="T50" fmla="*/ 264 w 513"/>
                <a:gd name="T51" fmla="*/ 21 h 59"/>
                <a:gd name="T52" fmla="*/ 274 w 513"/>
                <a:gd name="T53" fmla="*/ 20 h 59"/>
                <a:gd name="T54" fmla="*/ 285 w 513"/>
                <a:gd name="T55" fmla="*/ 19 h 59"/>
                <a:gd name="T56" fmla="*/ 295 w 513"/>
                <a:gd name="T57" fmla="*/ 18 h 59"/>
                <a:gd name="T58" fmla="*/ 305 w 513"/>
                <a:gd name="T59" fmla="*/ 17 h 59"/>
                <a:gd name="T60" fmla="*/ 316 w 513"/>
                <a:gd name="T61" fmla="*/ 16 h 59"/>
                <a:gd name="T62" fmla="*/ 326 w 513"/>
                <a:gd name="T63" fmla="*/ 15 h 59"/>
                <a:gd name="T64" fmla="*/ 337 w 513"/>
                <a:gd name="T65" fmla="*/ 14 h 59"/>
                <a:gd name="T66" fmla="*/ 347 w 513"/>
                <a:gd name="T67" fmla="*/ 13 h 59"/>
                <a:gd name="T68" fmla="*/ 357 w 513"/>
                <a:gd name="T69" fmla="*/ 12 h 59"/>
                <a:gd name="T70" fmla="*/ 368 w 513"/>
                <a:gd name="T71" fmla="*/ 11 h 59"/>
                <a:gd name="T72" fmla="*/ 378 w 513"/>
                <a:gd name="T73" fmla="*/ 10 h 59"/>
                <a:gd name="T74" fmla="*/ 388 w 513"/>
                <a:gd name="T75" fmla="*/ 9 h 59"/>
                <a:gd name="T76" fmla="*/ 399 w 513"/>
                <a:gd name="T77" fmla="*/ 8 h 59"/>
                <a:gd name="T78" fmla="*/ 409 w 513"/>
                <a:gd name="T79" fmla="*/ 7 h 59"/>
                <a:gd name="T80" fmla="*/ 419 w 513"/>
                <a:gd name="T81" fmla="*/ 6 h 59"/>
                <a:gd name="T82" fmla="*/ 430 w 513"/>
                <a:gd name="T83" fmla="*/ 6 h 59"/>
                <a:gd name="T84" fmla="*/ 440 w 513"/>
                <a:gd name="T85" fmla="*/ 5 h 59"/>
                <a:gd name="T86" fmla="*/ 450 w 513"/>
                <a:gd name="T87" fmla="*/ 4 h 59"/>
                <a:gd name="T88" fmla="*/ 461 w 513"/>
                <a:gd name="T89" fmla="*/ 3 h 59"/>
                <a:gd name="T90" fmla="*/ 471 w 513"/>
                <a:gd name="T91" fmla="*/ 3 h 59"/>
                <a:gd name="T92" fmla="*/ 482 w 513"/>
                <a:gd name="T93" fmla="*/ 2 h 59"/>
                <a:gd name="T94" fmla="*/ 492 w 513"/>
                <a:gd name="T95" fmla="*/ 1 h 59"/>
                <a:gd name="T96" fmla="*/ 502 w 513"/>
                <a:gd name="T97" fmla="*/ 0 h 59"/>
                <a:gd name="T98" fmla="*/ 513 w 513"/>
                <a:gd name="T99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513" h="59">
                  <a:moveTo>
                    <a:pt x="0" y="59"/>
                  </a:moveTo>
                  <a:lnTo>
                    <a:pt x="5" y="58"/>
                  </a:lnTo>
                  <a:lnTo>
                    <a:pt x="10" y="57"/>
                  </a:lnTo>
                  <a:lnTo>
                    <a:pt x="15" y="56"/>
                  </a:lnTo>
                  <a:lnTo>
                    <a:pt x="20" y="56"/>
                  </a:lnTo>
                  <a:lnTo>
                    <a:pt x="26" y="55"/>
                  </a:lnTo>
                  <a:lnTo>
                    <a:pt x="31" y="54"/>
                  </a:lnTo>
                  <a:lnTo>
                    <a:pt x="36" y="53"/>
                  </a:lnTo>
                  <a:lnTo>
                    <a:pt x="41" y="52"/>
                  </a:lnTo>
                  <a:lnTo>
                    <a:pt x="46" y="51"/>
                  </a:lnTo>
                  <a:lnTo>
                    <a:pt x="52" y="50"/>
                  </a:lnTo>
                  <a:lnTo>
                    <a:pt x="57" y="50"/>
                  </a:lnTo>
                  <a:lnTo>
                    <a:pt x="62" y="49"/>
                  </a:lnTo>
                  <a:lnTo>
                    <a:pt x="67" y="48"/>
                  </a:lnTo>
                  <a:lnTo>
                    <a:pt x="72" y="47"/>
                  </a:lnTo>
                  <a:lnTo>
                    <a:pt x="77" y="46"/>
                  </a:lnTo>
                  <a:lnTo>
                    <a:pt x="83" y="45"/>
                  </a:lnTo>
                  <a:lnTo>
                    <a:pt x="88" y="45"/>
                  </a:lnTo>
                  <a:lnTo>
                    <a:pt x="93" y="44"/>
                  </a:lnTo>
                  <a:lnTo>
                    <a:pt x="98" y="43"/>
                  </a:lnTo>
                  <a:lnTo>
                    <a:pt x="103" y="42"/>
                  </a:lnTo>
                  <a:lnTo>
                    <a:pt x="109" y="42"/>
                  </a:lnTo>
                  <a:lnTo>
                    <a:pt x="114" y="41"/>
                  </a:lnTo>
                  <a:lnTo>
                    <a:pt x="119" y="40"/>
                  </a:lnTo>
                  <a:lnTo>
                    <a:pt x="124" y="39"/>
                  </a:lnTo>
                  <a:lnTo>
                    <a:pt x="129" y="38"/>
                  </a:lnTo>
                  <a:lnTo>
                    <a:pt x="134" y="38"/>
                  </a:lnTo>
                  <a:lnTo>
                    <a:pt x="140" y="37"/>
                  </a:lnTo>
                  <a:lnTo>
                    <a:pt x="145" y="36"/>
                  </a:lnTo>
                  <a:lnTo>
                    <a:pt x="150" y="36"/>
                  </a:lnTo>
                  <a:lnTo>
                    <a:pt x="155" y="35"/>
                  </a:lnTo>
                  <a:lnTo>
                    <a:pt x="160" y="34"/>
                  </a:lnTo>
                  <a:lnTo>
                    <a:pt x="166" y="33"/>
                  </a:lnTo>
                  <a:lnTo>
                    <a:pt x="171" y="33"/>
                  </a:lnTo>
                  <a:lnTo>
                    <a:pt x="176" y="32"/>
                  </a:lnTo>
                  <a:lnTo>
                    <a:pt x="181" y="31"/>
                  </a:lnTo>
                  <a:lnTo>
                    <a:pt x="186" y="31"/>
                  </a:lnTo>
                  <a:lnTo>
                    <a:pt x="191" y="30"/>
                  </a:lnTo>
                  <a:lnTo>
                    <a:pt x="197" y="29"/>
                  </a:lnTo>
                  <a:lnTo>
                    <a:pt x="202" y="29"/>
                  </a:lnTo>
                  <a:lnTo>
                    <a:pt x="207" y="28"/>
                  </a:lnTo>
                  <a:lnTo>
                    <a:pt x="212" y="27"/>
                  </a:lnTo>
                  <a:lnTo>
                    <a:pt x="217" y="27"/>
                  </a:lnTo>
                  <a:lnTo>
                    <a:pt x="223" y="26"/>
                  </a:lnTo>
                  <a:lnTo>
                    <a:pt x="228" y="26"/>
                  </a:lnTo>
                  <a:lnTo>
                    <a:pt x="233" y="25"/>
                  </a:lnTo>
                  <a:lnTo>
                    <a:pt x="238" y="24"/>
                  </a:lnTo>
                  <a:lnTo>
                    <a:pt x="243" y="24"/>
                  </a:lnTo>
                  <a:lnTo>
                    <a:pt x="248" y="23"/>
                  </a:lnTo>
                  <a:lnTo>
                    <a:pt x="254" y="22"/>
                  </a:lnTo>
                  <a:lnTo>
                    <a:pt x="259" y="22"/>
                  </a:lnTo>
                  <a:lnTo>
                    <a:pt x="264" y="21"/>
                  </a:lnTo>
                  <a:lnTo>
                    <a:pt x="269" y="21"/>
                  </a:lnTo>
                  <a:lnTo>
                    <a:pt x="274" y="20"/>
                  </a:lnTo>
                  <a:lnTo>
                    <a:pt x="280" y="20"/>
                  </a:lnTo>
                  <a:lnTo>
                    <a:pt x="285" y="19"/>
                  </a:lnTo>
                  <a:lnTo>
                    <a:pt x="290" y="18"/>
                  </a:lnTo>
                  <a:lnTo>
                    <a:pt x="295" y="18"/>
                  </a:lnTo>
                  <a:lnTo>
                    <a:pt x="300" y="17"/>
                  </a:lnTo>
                  <a:lnTo>
                    <a:pt x="305" y="17"/>
                  </a:lnTo>
                  <a:lnTo>
                    <a:pt x="311" y="16"/>
                  </a:lnTo>
                  <a:lnTo>
                    <a:pt x="316" y="16"/>
                  </a:lnTo>
                  <a:lnTo>
                    <a:pt x="321" y="15"/>
                  </a:lnTo>
                  <a:lnTo>
                    <a:pt x="326" y="15"/>
                  </a:lnTo>
                  <a:lnTo>
                    <a:pt x="331" y="14"/>
                  </a:lnTo>
                  <a:lnTo>
                    <a:pt x="337" y="14"/>
                  </a:lnTo>
                  <a:lnTo>
                    <a:pt x="342" y="13"/>
                  </a:lnTo>
                  <a:lnTo>
                    <a:pt x="347" y="13"/>
                  </a:lnTo>
                  <a:lnTo>
                    <a:pt x="352" y="12"/>
                  </a:lnTo>
                  <a:lnTo>
                    <a:pt x="357" y="12"/>
                  </a:lnTo>
                  <a:lnTo>
                    <a:pt x="362" y="11"/>
                  </a:lnTo>
                  <a:lnTo>
                    <a:pt x="368" y="11"/>
                  </a:lnTo>
                  <a:lnTo>
                    <a:pt x="373" y="10"/>
                  </a:lnTo>
                  <a:lnTo>
                    <a:pt x="378" y="10"/>
                  </a:lnTo>
                  <a:lnTo>
                    <a:pt x="383" y="9"/>
                  </a:lnTo>
                  <a:lnTo>
                    <a:pt x="388" y="9"/>
                  </a:lnTo>
                  <a:lnTo>
                    <a:pt x="393" y="9"/>
                  </a:lnTo>
                  <a:lnTo>
                    <a:pt x="399" y="8"/>
                  </a:lnTo>
                  <a:lnTo>
                    <a:pt x="404" y="8"/>
                  </a:lnTo>
                  <a:lnTo>
                    <a:pt x="409" y="7"/>
                  </a:lnTo>
                  <a:lnTo>
                    <a:pt x="414" y="7"/>
                  </a:lnTo>
                  <a:lnTo>
                    <a:pt x="419" y="6"/>
                  </a:lnTo>
                  <a:lnTo>
                    <a:pt x="425" y="6"/>
                  </a:lnTo>
                  <a:lnTo>
                    <a:pt x="430" y="6"/>
                  </a:lnTo>
                  <a:lnTo>
                    <a:pt x="435" y="5"/>
                  </a:lnTo>
                  <a:lnTo>
                    <a:pt x="440" y="5"/>
                  </a:lnTo>
                  <a:lnTo>
                    <a:pt x="445" y="4"/>
                  </a:lnTo>
                  <a:lnTo>
                    <a:pt x="450" y="4"/>
                  </a:lnTo>
                  <a:lnTo>
                    <a:pt x="456" y="4"/>
                  </a:lnTo>
                  <a:lnTo>
                    <a:pt x="461" y="3"/>
                  </a:lnTo>
                  <a:lnTo>
                    <a:pt x="466" y="3"/>
                  </a:lnTo>
                  <a:lnTo>
                    <a:pt x="471" y="3"/>
                  </a:lnTo>
                  <a:lnTo>
                    <a:pt x="476" y="2"/>
                  </a:lnTo>
                  <a:lnTo>
                    <a:pt x="482" y="2"/>
                  </a:lnTo>
                  <a:lnTo>
                    <a:pt x="487" y="1"/>
                  </a:lnTo>
                  <a:lnTo>
                    <a:pt x="492" y="1"/>
                  </a:lnTo>
                  <a:lnTo>
                    <a:pt x="497" y="1"/>
                  </a:lnTo>
                  <a:lnTo>
                    <a:pt x="502" y="0"/>
                  </a:lnTo>
                  <a:lnTo>
                    <a:pt x="507" y="0"/>
                  </a:lnTo>
                  <a:lnTo>
                    <a:pt x="513" y="0"/>
                  </a:lnTo>
                </a:path>
              </a:pathLst>
            </a:cu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" name="Rectangle 97">
              <a:extLst>
                <a:ext uri="{FF2B5EF4-FFF2-40B4-BE49-F238E27FC236}">
                  <a16:creationId xmlns:a16="http://schemas.microsoft.com/office/drawing/2014/main" id="{1150E49A-2C1D-968C-758A-CA78F17375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" y="877"/>
              <a:ext cx="1591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it(p) = 0.87 + 83.53 * 1/m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Freeform 98">
              <a:extLst>
                <a:ext uri="{FF2B5EF4-FFF2-40B4-BE49-F238E27FC236}">
                  <a16:creationId xmlns:a16="http://schemas.microsoft.com/office/drawing/2014/main" id="{EE5B4245-AEC2-B2C3-A358-A0E4671AC7F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973" y="799"/>
              <a:ext cx="0" cy="2279"/>
            </a:xfrm>
            <a:custGeom>
              <a:avLst/>
              <a:gdLst>
                <a:gd name="T0" fmla="*/ 489 h 496"/>
                <a:gd name="T1" fmla="*/ 481 h 496"/>
                <a:gd name="T2" fmla="*/ 473 h 496"/>
                <a:gd name="T3" fmla="*/ 465 h 496"/>
                <a:gd name="T4" fmla="*/ 457 h 496"/>
                <a:gd name="T5" fmla="*/ 449 h 496"/>
                <a:gd name="T6" fmla="*/ 441 h 496"/>
                <a:gd name="T7" fmla="*/ 433 h 496"/>
                <a:gd name="T8" fmla="*/ 425 h 496"/>
                <a:gd name="T9" fmla="*/ 417 h 496"/>
                <a:gd name="T10" fmla="*/ 409 h 496"/>
                <a:gd name="T11" fmla="*/ 401 h 496"/>
                <a:gd name="T12" fmla="*/ 393 h 496"/>
                <a:gd name="T13" fmla="*/ 385 h 496"/>
                <a:gd name="T14" fmla="*/ 377 h 496"/>
                <a:gd name="T15" fmla="*/ 369 h 496"/>
                <a:gd name="T16" fmla="*/ 361 h 496"/>
                <a:gd name="T17" fmla="*/ 353 h 496"/>
                <a:gd name="T18" fmla="*/ 345 h 496"/>
                <a:gd name="T19" fmla="*/ 337 h 496"/>
                <a:gd name="T20" fmla="*/ 329 h 496"/>
                <a:gd name="T21" fmla="*/ 321 h 496"/>
                <a:gd name="T22" fmla="*/ 313 h 496"/>
                <a:gd name="T23" fmla="*/ 305 h 496"/>
                <a:gd name="T24" fmla="*/ 297 h 496"/>
                <a:gd name="T25" fmla="*/ 289 h 496"/>
                <a:gd name="T26" fmla="*/ 281 h 496"/>
                <a:gd name="T27" fmla="*/ 273 h 496"/>
                <a:gd name="T28" fmla="*/ 265 h 496"/>
                <a:gd name="T29" fmla="*/ 257 h 496"/>
                <a:gd name="T30" fmla="*/ 249 h 496"/>
                <a:gd name="T31" fmla="*/ 241 h 496"/>
                <a:gd name="T32" fmla="*/ 233 h 496"/>
                <a:gd name="T33" fmla="*/ 225 h 496"/>
                <a:gd name="T34" fmla="*/ 217 h 496"/>
                <a:gd name="T35" fmla="*/ 209 h 496"/>
                <a:gd name="T36" fmla="*/ 201 h 496"/>
                <a:gd name="T37" fmla="*/ 193 h 496"/>
                <a:gd name="T38" fmla="*/ 185 h 496"/>
                <a:gd name="T39" fmla="*/ 177 h 496"/>
                <a:gd name="T40" fmla="*/ 169 h 496"/>
                <a:gd name="T41" fmla="*/ 161 h 496"/>
                <a:gd name="T42" fmla="*/ 153 h 496"/>
                <a:gd name="T43" fmla="*/ 145 h 496"/>
                <a:gd name="T44" fmla="*/ 137 h 496"/>
                <a:gd name="T45" fmla="*/ 129 h 496"/>
                <a:gd name="T46" fmla="*/ 121 h 496"/>
                <a:gd name="T47" fmla="*/ 113 h 496"/>
                <a:gd name="T48" fmla="*/ 105 h 496"/>
                <a:gd name="T49" fmla="*/ 97 h 496"/>
                <a:gd name="T50" fmla="*/ 89 h 496"/>
                <a:gd name="T51" fmla="*/ 81 h 496"/>
                <a:gd name="T52" fmla="*/ 73 h 496"/>
                <a:gd name="T53" fmla="*/ 65 h 496"/>
                <a:gd name="T54" fmla="*/ 57 h 496"/>
                <a:gd name="T55" fmla="*/ 49 h 496"/>
                <a:gd name="T56" fmla="*/ 41 h 496"/>
                <a:gd name="T57" fmla="*/ 33 h 496"/>
                <a:gd name="T58" fmla="*/ 25 h 496"/>
                <a:gd name="T59" fmla="*/ 17 h 496"/>
                <a:gd name="T60" fmla="*/ 9 h 496"/>
                <a:gd name="T61" fmla="*/ 1 h 4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  <a:cxn ang="0">
                  <a:pos x="0" y="T61"/>
                </a:cxn>
              </a:cxnLst>
              <a:rect l="0" t="0" r="r" b="b"/>
              <a:pathLst>
                <a:path h="496"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" name="Freeform 99">
              <a:extLst>
                <a:ext uri="{FF2B5EF4-FFF2-40B4-BE49-F238E27FC236}">
                  <a16:creationId xmlns:a16="http://schemas.microsoft.com/office/drawing/2014/main" id="{82E67545-8DD3-937F-5C7E-AEDE13D9C14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488" y="799"/>
              <a:ext cx="0" cy="2279"/>
            </a:xfrm>
            <a:custGeom>
              <a:avLst/>
              <a:gdLst>
                <a:gd name="T0" fmla="*/ 489 h 496"/>
                <a:gd name="T1" fmla="*/ 481 h 496"/>
                <a:gd name="T2" fmla="*/ 473 h 496"/>
                <a:gd name="T3" fmla="*/ 465 h 496"/>
                <a:gd name="T4" fmla="*/ 457 h 496"/>
                <a:gd name="T5" fmla="*/ 449 h 496"/>
                <a:gd name="T6" fmla="*/ 441 h 496"/>
                <a:gd name="T7" fmla="*/ 433 h 496"/>
                <a:gd name="T8" fmla="*/ 425 h 496"/>
                <a:gd name="T9" fmla="*/ 417 h 496"/>
                <a:gd name="T10" fmla="*/ 409 h 496"/>
                <a:gd name="T11" fmla="*/ 401 h 496"/>
                <a:gd name="T12" fmla="*/ 393 h 496"/>
                <a:gd name="T13" fmla="*/ 385 h 496"/>
                <a:gd name="T14" fmla="*/ 377 h 496"/>
                <a:gd name="T15" fmla="*/ 369 h 496"/>
                <a:gd name="T16" fmla="*/ 361 h 496"/>
                <a:gd name="T17" fmla="*/ 353 h 496"/>
                <a:gd name="T18" fmla="*/ 345 h 496"/>
                <a:gd name="T19" fmla="*/ 337 h 496"/>
                <a:gd name="T20" fmla="*/ 329 h 496"/>
                <a:gd name="T21" fmla="*/ 321 h 496"/>
                <a:gd name="T22" fmla="*/ 313 h 496"/>
                <a:gd name="T23" fmla="*/ 305 h 496"/>
                <a:gd name="T24" fmla="*/ 297 h 496"/>
                <a:gd name="T25" fmla="*/ 289 h 496"/>
                <a:gd name="T26" fmla="*/ 281 h 496"/>
                <a:gd name="T27" fmla="*/ 273 h 496"/>
                <a:gd name="T28" fmla="*/ 265 h 496"/>
                <a:gd name="T29" fmla="*/ 257 h 496"/>
                <a:gd name="T30" fmla="*/ 249 h 496"/>
                <a:gd name="T31" fmla="*/ 241 h 496"/>
                <a:gd name="T32" fmla="*/ 233 h 496"/>
                <a:gd name="T33" fmla="*/ 225 h 496"/>
                <a:gd name="T34" fmla="*/ 217 h 496"/>
                <a:gd name="T35" fmla="*/ 209 h 496"/>
                <a:gd name="T36" fmla="*/ 201 h 496"/>
                <a:gd name="T37" fmla="*/ 193 h 496"/>
                <a:gd name="T38" fmla="*/ 185 h 496"/>
                <a:gd name="T39" fmla="*/ 177 h 496"/>
                <a:gd name="T40" fmla="*/ 169 h 496"/>
                <a:gd name="T41" fmla="*/ 161 h 496"/>
                <a:gd name="T42" fmla="*/ 153 h 496"/>
                <a:gd name="T43" fmla="*/ 145 h 496"/>
                <a:gd name="T44" fmla="*/ 137 h 496"/>
                <a:gd name="T45" fmla="*/ 129 h 496"/>
                <a:gd name="T46" fmla="*/ 121 h 496"/>
                <a:gd name="T47" fmla="*/ 113 h 496"/>
                <a:gd name="T48" fmla="*/ 105 h 496"/>
                <a:gd name="T49" fmla="*/ 97 h 496"/>
                <a:gd name="T50" fmla="*/ 89 h 496"/>
                <a:gd name="T51" fmla="*/ 81 h 496"/>
                <a:gd name="T52" fmla="*/ 73 h 496"/>
                <a:gd name="T53" fmla="*/ 65 h 496"/>
                <a:gd name="T54" fmla="*/ 57 h 496"/>
                <a:gd name="T55" fmla="*/ 49 h 496"/>
                <a:gd name="T56" fmla="*/ 41 h 496"/>
                <a:gd name="T57" fmla="*/ 33 h 496"/>
                <a:gd name="T58" fmla="*/ 25 h 496"/>
                <a:gd name="T59" fmla="*/ 17 h 496"/>
                <a:gd name="T60" fmla="*/ 9 h 496"/>
                <a:gd name="T61" fmla="*/ 1 h 4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  <a:cxn ang="0">
                  <a:pos x="0" y="T61"/>
                </a:cxn>
              </a:cxnLst>
              <a:rect l="0" t="0" r="r" b="b"/>
              <a:pathLst>
                <a:path h="496"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" name="Freeform 100">
              <a:extLst>
                <a:ext uri="{FF2B5EF4-FFF2-40B4-BE49-F238E27FC236}">
                  <a16:creationId xmlns:a16="http://schemas.microsoft.com/office/drawing/2014/main" id="{36050FFF-5089-F90C-3A5D-F414E2A30EE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02" y="799"/>
              <a:ext cx="0" cy="2279"/>
            </a:xfrm>
            <a:custGeom>
              <a:avLst/>
              <a:gdLst>
                <a:gd name="T0" fmla="*/ 489 h 496"/>
                <a:gd name="T1" fmla="*/ 481 h 496"/>
                <a:gd name="T2" fmla="*/ 473 h 496"/>
                <a:gd name="T3" fmla="*/ 465 h 496"/>
                <a:gd name="T4" fmla="*/ 457 h 496"/>
                <a:gd name="T5" fmla="*/ 449 h 496"/>
                <a:gd name="T6" fmla="*/ 441 h 496"/>
                <a:gd name="T7" fmla="*/ 433 h 496"/>
                <a:gd name="T8" fmla="*/ 425 h 496"/>
                <a:gd name="T9" fmla="*/ 417 h 496"/>
                <a:gd name="T10" fmla="*/ 409 h 496"/>
                <a:gd name="T11" fmla="*/ 401 h 496"/>
                <a:gd name="T12" fmla="*/ 393 h 496"/>
                <a:gd name="T13" fmla="*/ 385 h 496"/>
                <a:gd name="T14" fmla="*/ 377 h 496"/>
                <a:gd name="T15" fmla="*/ 369 h 496"/>
                <a:gd name="T16" fmla="*/ 361 h 496"/>
                <a:gd name="T17" fmla="*/ 353 h 496"/>
                <a:gd name="T18" fmla="*/ 345 h 496"/>
                <a:gd name="T19" fmla="*/ 337 h 496"/>
                <a:gd name="T20" fmla="*/ 329 h 496"/>
                <a:gd name="T21" fmla="*/ 321 h 496"/>
                <a:gd name="T22" fmla="*/ 313 h 496"/>
                <a:gd name="T23" fmla="*/ 305 h 496"/>
                <a:gd name="T24" fmla="*/ 297 h 496"/>
                <a:gd name="T25" fmla="*/ 289 h 496"/>
                <a:gd name="T26" fmla="*/ 281 h 496"/>
                <a:gd name="T27" fmla="*/ 273 h 496"/>
                <a:gd name="T28" fmla="*/ 265 h 496"/>
                <a:gd name="T29" fmla="*/ 257 h 496"/>
                <a:gd name="T30" fmla="*/ 249 h 496"/>
                <a:gd name="T31" fmla="*/ 241 h 496"/>
                <a:gd name="T32" fmla="*/ 233 h 496"/>
                <a:gd name="T33" fmla="*/ 225 h 496"/>
                <a:gd name="T34" fmla="*/ 217 h 496"/>
                <a:gd name="T35" fmla="*/ 209 h 496"/>
                <a:gd name="T36" fmla="*/ 201 h 496"/>
                <a:gd name="T37" fmla="*/ 193 h 496"/>
                <a:gd name="T38" fmla="*/ 185 h 496"/>
                <a:gd name="T39" fmla="*/ 177 h 496"/>
                <a:gd name="T40" fmla="*/ 169 h 496"/>
                <a:gd name="T41" fmla="*/ 161 h 496"/>
                <a:gd name="T42" fmla="*/ 153 h 496"/>
                <a:gd name="T43" fmla="*/ 145 h 496"/>
                <a:gd name="T44" fmla="*/ 137 h 496"/>
                <a:gd name="T45" fmla="*/ 129 h 496"/>
                <a:gd name="T46" fmla="*/ 121 h 496"/>
                <a:gd name="T47" fmla="*/ 113 h 496"/>
                <a:gd name="T48" fmla="*/ 105 h 496"/>
                <a:gd name="T49" fmla="*/ 97 h 496"/>
                <a:gd name="T50" fmla="*/ 89 h 496"/>
                <a:gd name="T51" fmla="*/ 81 h 496"/>
                <a:gd name="T52" fmla="*/ 73 h 496"/>
                <a:gd name="T53" fmla="*/ 65 h 496"/>
                <a:gd name="T54" fmla="*/ 57 h 496"/>
                <a:gd name="T55" fmla="*/ 49 h 496"/>
                <a:gd name="T56" fmla="*/ 41 h 496"/>
                <a:gd name="T57" fmla="*/ 33 h 496"/>
                <a:gd name="T58" fmla="*/ 25 h 496"/>
                <a:gd name="T59" fmla="*/ 17 h 496"/>
                <a:gd name="T60" fmla="*/ 9 h 496"/>
                <a:gd name="T61" fmla="*/ 1 h 4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  <a:cxn ang="0">
                  <a:pos x="0" y="T61"/>
                </a:cxn>
              </a:cxnLst>
              <a:rect l="0" t="0" r="r" b="b"/>
              <a:pathLst>
                <a:path h="496"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" name="Freeform 101">
              <a:extLst>
                <a:ext uri="{FF2B5EF4-FFF2-40B4-BE49-F238E27FC236}">
                  <a16:creationId xmlns:a16="http://schemas.microsoft.com/office/drawing/2014/main" id="{6C9D1D12-2B55-44CB-E97C-DAC0AA5545B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517" y="799"/>
              <a:ext cx="0" cy="2279"/>
            </a:xfrm>
            <a:custGeom>
              <a:avLst/>
              <a:gdLst>
                <a:gd name="T0" fmla="*/ 489 h 496"/>
                <a:gd name="T1" fmla="*/ 481 h 496"/>
                <a:gd name="T2" fmla="*/ 473 h 496"/>
                <a:gd name="T3" fmla="*/ 465 h 496"/>
                <a:gd name="T4" fmla="*/ 457 h 496"/>
                <a:gd name="T5" fmla="*/ 449 h 496"/>
                <a:gd name="T6" fmla="*/ 441 h 496"/>
                <a:gd name="T7" fmla="*/ 433 h 496"/>
                <a:gd name="T8" fmla="*/ 425 h 496"/>
                <a:gd name="T9" fmla="*/ 417 h 496"/>
                <a:gd name="T10" fmla="*/ 409 h 496"/>
                <a:gd name="T11" fmla="*/ 401 h 496"/>
                <a:gd name="T12" fmla="*/ 393 h 496"/>
                <a:gd name="T13" fmla="*/ 385 h 496"/>
                <a:gd name="T14" fmla="*/ 377 h 496"/>
                <a:gd name="T15" fmla="*/ 369 h 496"/>
                <a:gd name="T16" fmla="*/ 361 h 496"/>
                <a:gd name="T17" fmla="*/ 353 h 496"/>
                <a:gd name="T18" fmla="*/ 345 h 496"/>
                <a:gd name="T19" fmla="*/ 337 h 496"/>
                <a:gd name="T20" fmla="*/ 329 h 496"/>
                <a:gd name="T21" fmla="*/ 321 h 496"/>
                <a:gd name="T22" fmla="*/ 313 h 496"/>
                <a:gd name="T23" fmla="*/ 305 h 496"/>
                <a:gd name="T24" fmla="*/ 297 h 496"/>
                <a:gd name="T25" fmla="*/ 289 h 496"/>
                <a:gd name="T26" fmla="*/ 281 h 496"/>
                <a:gd name="T27" fmla="*/ 273 h 496"/>
                <a:gd name="T28" fmla="*/ 265 h 496"/>
                <a:gd name="T29" fmla="*/ 257 h 496"/>
                <a:gd name="T30" fmla="*/ 249 h 496"/>
                <a:gd name="T31" fmla="*/ 241 h 496"/>
                <a:gd name="T32" fmla="*/ 233 h 496"/>
                <a:gd name="T33" fmla="*/ 225 h 496"/>
                <a:gd name="T34" fmla="*/ 217 h 496"/>
                <a:gd name="T35" fmla="*/ 209 h 496"/>
                <a:gd name="T36" fmla="*/ 201 h 496"/>
                <a:gd name="T37" fmla="*/ 193 h 496"/>
                <a:gd name="T38" fmla="*/ 185 h 496"/>
                <a:gd name="T39" fmla="*/ 177 h 496"/>
                <a:gd name="T40" fmla="*/ 169 h 496"/>
                <a:gd name="T41" fmla="*/ 161 h 496"/>
                <a:gd name="T42" fmla="*/ 153 h 496"/>
                <a:gd name="T43" fmla="*/ 145 h 496"/>
                <a:gd name="T44" fmla="*/ 137 h 496"/>
                <a:gd name="T45" fmla="*/ 129 h 496"/>
                <a:gd name="T46" fmla="*/ 121 h 496"/>
                <a:gd name="T47" fmla="*/ 113 h 496"/>
                <a:gd name="T48" fmla="*/ 105 h 496"/>
                <a:gd name="T49" fmla="*/ 97 h 496"/>
                <a:gd name="T50" fmla="*/ 89 h 496"/>
                <a:gd name="T51" fmla="*/ 81 h 496"/>
                <a:gd name="T52" fmla="*/ 73 h 496"/>
                <a:gd name="T53" fmla="*/ 65 h 496"/>
                <a:gd name="T54" fmla="*/ 57 h 496"/>
                <a:gd name="T55" fmla="*/ 49 h 496"/>
                <a:gd name="T56" fmla="*/ 41 h 496"/>
                <a:gd name="T57" fmla="*/ 33 h 496"/>
                <a:gd name="T58" fmla="*/ 25 h 496"/>
                <a:gd name="T59" fmla="*/ 17 h 496"/>
                <a:gd name="T60" fmla="*/ 9 h 496"/>
                <a:gd name="T61" fmla="*/ 1 h 4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  <a:cxn ang="0">
                  <a:pos x="0" y="T61"/>
                </a:cxn>
              </a:cxnLst>
              <a:rect l="0" t="0" r="r" b="b"/>
              <a:pathLst>
                <a:path h="496"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" name="Freeform 102">
              <a:extLst>
                <a:ext uri="{FF2B5EF4-FFF2-40B4-BE49-F238E27FC236}">
                  <a16:creationId xmlns:a16="http://schemas.microsoft.com/office/drawing/2014/main" id="{9D5B87EE-7A64-DF23-47CE-540D58BE82A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031" y="799"/>
              <a:ext cx="0" cy="2279"/>
            </a:xfrm>
            <a:custGeom>
              <a:avLst/>
              <a:gdLst>
                <a:gd name="T0" fmla="*/ 489 h 496"/>
                <a:gd name="T1" fmla="*/ 481 h 496"/>
                <a:gd name="T2" fmla="*/ 473 h 496"/>
                <a:gd name="T3" fmla="*/ 465 h 496"/>
                <a:gd name="T4" fmla="*/ 457 h 496"/>
                <a:gd name="T5" fmla="*/ 449 h 496"/>
                <a:gd name="T6" fmla="*/ 441 h 496"/>
                <a:gd name="T7" fmla="*/ 433 h 496"/>
                <a:gd name="T8" fmla="*/ 425 h 496"/>
                <a:gd name="T9" fmla="*/ 417 h 496"/>
                <a:gd name="T10" fmla="*/ 409 h 496"/>
                <a:gd name="T11" fmla="*/ 401 h 496"/>
                <a:gd name="T12" fmla="*/ 393 h 496"/>
                <a:gd name="T13" fmla="*/ 385 h 496"/>
                <a:gd name="T14" fmla="*/ 377 h 496"/>
                <a:gd name="T15" fmla="*/ 369 h 496"/>
                <a:gd name="T16" fmla="*/ 361 h 496"/>
                <a:gd name="T17" fmla="*/ 353 h 496"/>
                <a:gd name="T18" fmla="*/ 345 h 496"/>
                <a:gd name="T19" fmla="*/ 337 h 496"/>
                <a:gd name="T20" fmla="*/ 329 h 496"/>
                <a:gd name="T21" fmla="*/ 321 h 496"/>
                <a:gd name="T22" fmla="*/ 313 h 496"/>
                <a:gd name="T23" fmla="*/ 305 h 496"/>
                <a:gd name="T24" fmla="*/ 297 h 496"/>
                <a:gd name="T25" fmla="*/ 289 h 496"/>
                <a:gd name="T26" fmla="*/ 281 h 496"/>
                <a:gd name="T27" fmla="*/ 273 h 496"/>
                <a:gd name="T28" fmla="*/ 265 h 496"/>
                <a:gd name="T29" fmla="*/ 257 h 496"/>
                <a:gd name="T30" fmla="*/ 249 h 496"/>
                <a:gd name="T31" fmla="*/ 241 h 496"/>
                <a:gd name="T32" fmla="*/ 233 h 496"/>
                <a:gd name="T33" fmla="*/ 225 h 496"/>
                <a:gd name="T34" fmla="*/ 217 h 496"/>
                <a:gd name="T35" fmla="*/ 209 h 496"/>
                <a:gd name="T36" fmla="*/ 201 h 496"/>
                <a:gd name="T37" fmla="*/ 193 h 496"/>
                <a:gd name="T38" fmla="*/ 185 h 496"/>
                <a:gd name="T39" fmla="*/ 177 h 496"/>
                <a:gd name="T40" fmla="*/ 169 h 496"/>
                <a:gd name="T41" fmla="*/ 161 h 496"/>
                <a:gd name="T42" fmla="*/ 153 h 496"/>
                <a:gd name="T43" fmla="*/ 145 h 496"/>
                <a:gd name="T44" fmla="*/ 137 h 496"/>
                <a:gd name="T45" fmla="*/ 129 h 496"/>
                <a:gd name="T46" fmla="*/ 121 h 496"/>
                <a:gd name="T47" fmla="*/ 113 h 496"/>
                <a:gd name="T48" fmla="*/ 105 h 496"/>
                <a:gd name="T49" fmla="*/ 97 h 496"/>
                <a:gd name="T50" fmla="*/ 89 h 496"/>
                <a:gd name="T51" fmla="*/ 81 h 496"/>
                <a:gd name="T52" fmla="*/ 73 h 496"/>
                <a:gd name="T53" fmla="*/ 65 h 496"/>
                <a:gd name="T54" fmla="*/ 57 h 496"/>
                <a:gd name="T55" fmla="*/ 49 h 496"/>
                <a:gd name="T56" fmla="*/ 41 h 496"/>
                <a:gd name="T57" fmla="*/ 33 h 496"/>
                <a:gd name="T58" fmla="*/ 25 h 496"/>
                <a:gd name="T59" fmla="*/ 17 h 496"/>
                <a:gd name="T60" fmla="*/ 9 h 496"/>
                <a:gd name="T61" fmla="*/ 1 h 4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  <a:cxn ang="0">
                  <a:pos x="0" y="T61"/>
                </a:cxn>
              </a:cxnLst>
              <a:rect l="0" t="0" r="r" b="b"/>
              <a:pathLst>
                <a:path h="496"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Freeform 103">
              <a:extLst>
                <a:ext uri="{FF2B5EF4-FFF2-40B4-BE49-F238E27FC236}">
                  <a16:creationId xmlns:a16="http://schemas.microsoft.com/office/drawing/2014/main" id="{F12994B3-80D6-09B4-828F-0EB9689BEE0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83" y="2995"/>
              <a:ext cx="25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Freeform 104">
              <a:extLst>
                <a:ext uri="{FF2B5EF4-FFF2-40B4-BE49-F238E27FC236}">
                  <a16:creationId xmlns:a16="http://schemas.microsoft.com/office/drawing/2014/main" id="{5CF42E7E-7500-B810-B92F-C236C8BD94F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83" y="2572"/>
              <a:ext cx="25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Freeform 105">
              <a:extLst>
                <a:ext uri="{FF2B5EF4-FFF2-40B4-BE49-F238E27FC236}">
                  <a16:creationId xmlns:a16="http://schemas.microsoft.com/office/drawing/2014/main" id="{B32A51D3-21B7-6875-F945-3E7E5739DD4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83" y="2150"/>
              <a:ext cx="25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Freeform 106">
              <a:extLst>
                <a:ext uri="{FF2B5EF4-FFF2-40B4-BE49-F238E27FC236}">
                  <a16:creationId xmlns:a16="http://schemas.microsoft.com/office/drawing/2014/main" id="{81D902AD-FF88-AFD3-53E9-BA905CA97D4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83" y="1727"/>
              <a:ext cx="25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" name="Freeform 107">
              <a:extLst>
                <a:ext uri="{FF2B5EF4-FFF2-40B4-BE49-F238E27FC236}">
                  <a16:creationId xmlns:a16="http://schemas.microsoft.com/office/drawing/2014/main" id="{7519503E-FBF3-D067-8AFE-06CA8ED9BCD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83" y="1309"/>
              <a:ext cx="25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" name="Freeform 108">
              <a:extLst>
                <a:ext uri="{FF2B5EF4-FFF2-40B4-BE49-F238E27FC236}">
                  <a16:creationId xmlns:a16="http://schemas.microsoft.com/office/drawing/2014/main" id="{21267860-F2EC-1D03-E3DA-00A4A4797C0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83" y="887"/>
              <a:ext cx="25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16" name="Group 111">
            <a:extLst>
              <a:ext uri="{FF2B5EF4-FFF2-40B4-BE49-F238E27FC236}">
                <a16:creationId xmlns:a16="http://schemas.microsoft.com/office/drawing/2014/main" id="{33E9FF91-9786-5EEF-00B0-55F54FAC4F34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036867" y="5843860"/>
            <a:ext cx="4451352" cy="4076698"/>
            <a:chOff x="1335" y="3863"/>
            <a:chExt cx="2804" cy="2568"/>
          </a:xfrm>
        </p:grpSpPr>
        <p:sp>
          <p:nvSpPr>
            <p:cNvPr id="118" name="Rectangle 112">
              <a:extLst>
                <a:ext uri="{FF2B5EF4-FFF2-40B4-BE49-F238E27FC236}">
                  <a16:creationId xmlns:a16="http://schemas.microsoft.com/office/drawing/2014/main" id="{0EF2C87D-E899-E398-1CF8-0D15C8A839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8" y="3934"/>
              <a:ext cx="1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Rectangle 113">
              <a:extLst>
                <a:ext uri="{FF2B5EF4-FFF2-40B4-BE49-F238E27FC236}">
                  <a16:creationId xmlns:a16="http://schemas.microsoft.com/office/drawing/2014/main" id="{A2F99BEA-7B8D-97D4-B82A-E675D20675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8" y="3960"/>
              <a:ext cx="1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" name="Rectangle 114">
              <a:extLst>
                <a:ext uri="{FF2B5EF4-FFF2-40B4-BE49-F238E27FC236}">
                  <a16:creationId xmlns:a16="http://schemas.microsoft.com/office/drawing/2014/main" id="{8FC77520-087C-5D10-85BB-14819EE555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4" y="3938"/>
              <a:ext cx="2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Rectangle 115">
              <a:extLst>
                <a:ext uri="{FF2B5EF4-FFF2-40B4-BE49-F238E27FC236}">
                  <a16:creationId xmlns:a16="http://schemas.microsoft.com/office/drawing/2014/main" id="{D393B01C-53AF-D062-4FAB-D3200D92E9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4" y="3956"/>
              <a:ext cx="2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" name="Rectangle 116">
              <a:extLst>
                <a:ext uri="{FF2B5EF4-FFF2-40B4-BE49-F238E27FC236}">
                  <a16:creationId xmlns:a16="http://schemas.microsoft.com/office/drawing/2014/main" id="{DC2B788C-D4B2-CD98-CEDD-3613E337A9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9" y="3942"/>
              <a:ext cx="31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" name="Rectangle 117">
              <a:extLst>
                <a:ext uri="{FF2B5EF4-FFF2-40B4-BE49-F238E27FC236}">
                  <a16:creationId xmlns:a16="http://schemas.microsoft.com/office/drawing/2014/main" id="{F5A7B758-33CA-97D0-CE65-4F625F4D03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9" y="3951"/>
              <a:ext cx="31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" name="Rectangle 118">
              <a:extLst>
                <a:ext uri="{FF2B5EF4-FFF2-40B4-BE49-F238E27FC236}">
                  <a16:creationId xmlns:a16="http://schemas.microsoft.com/office/drawing/2014/main" id="{80F9C46F-AA5C-2A6F-8ECB-F3D67316A3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9" y="3947"/>
              <a:ext cx="3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" name="Rectangle 119">
              <a:extLst>
                <a:ext uri="{FF2B5EF4-FFF2-40B4-BE49-F238E27FC236}">
                  <a16:creationId xmlns:a16="http://schemas.microsoft.com/office/drawing/2014/main" id="{C2273790-0237-D3D4-43CB-4875F4833B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9" y="3947"/>
              <a:ext cx="3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" name="Oval 120">
              <a:extLst>
                <a:ext uri="{FF2B5EF4-FFF2-40B4-BE49-F238E27FC236}">
                  <a16:creationId xmlns:a16="http://schemas.microsoft.com/office/drawing/2014/main" id="{136A039E-74BD-A37A-F4E9-C44A3DFE34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9" y="3934"/>
              <a:ext cx="27" cy="26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" name="Rectangle 121">
              <a:extLst>
                <a:ext uri="{FF2B5EF4-FFF2-40B4-BE49-F238E27FC236}">
                  <a16:creationId xmlns:a16="http://schemas.microsoft.com/office/drawing/2014/main" id="{0FC85641-E106-9AD2-4B7B-7D65F94C30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0" y="3934"/>
              <a:ext cx="1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" name="Rectangle 122">
              <a:extLst>
                <a:ext uri="{FF2B5EF4-FFF2-40B4-BE49-F238E27FC236}">
                  <a16:creationId xmlns:a16="http://schemas.microsoft.com/office/drawing/2014/main" id="{3B69DA05-4909-4801-5BCE-B52320F4D7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0" y="3960"/>
              <a:ext cx="1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" name="Rectangle 123">
              <a:extLst>
                <a:ext uri="{FF2B5EF4-FFF2-40B4-BE49-F238E27FC236}">
                  <a16:creationId xmlns:a16="http://schemas.microsoft.com/office/drawing/2014/main" id="{0987F8F7-E833-B83D-9983-5B03E3F4C0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6" y="3938"/>
              <a:ext cx="2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" name="Rectangle 124">
              <a:extLst>
                <a:ext uri="{FF2B5EF4-FFF2-40B4-BE49-F238E27FC236}">
                  <a16:creationId xmlns:a16="http://schemas.microsoft.com/office/drawing/2014/main" id="{B33697FD-D966-D51E-5B6B-A87D451D0C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6" y="3956"/>
              <a:ext cx="2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" name="Rectangle 125">
              <a:extLst>
                <a:ext uri="{FF2B5EF4-FFF2-40B4-BE49-F238E27FC236}">
                  <a16:creationId xmlns:a16="http://schemas.microsoft.com/office/drawing/2014/main" id="{C0FF2658-9835-4E11-DB41-FB7FC0C699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1" y="3942"/>
              <a:ext cx="31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" name="Rectangle 126">
              <a:extLst>
                <a:ext uri="{FF2B5EF4-FFF2-40B4-BE49-F238E27FC236}">
                  <a16:creationId xmlns:a16="http://schemas.microsoft.com/office/drawing/2014/main" id="{7F512362-2DCF-05A5-06B8-05A4ED6813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1" y="3951"/>
              <a:ext cx="31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" name="Rectangle 127">
              <a:extLst>
                <a:ext uri="{FF2B5EF4-FFF2-40B4-BE49-F238E27FC236}">
                  <a16:creationId xmlns:a16="http://schemas.microsoft.com/office/drawing/2014/main" id="{EDA89EEC-3F42-83AC-DA23-5E7FF6D6C7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1" y="3947"/>
              <a:ext cx="3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" name="Rectangle 128">
              <a:extLst>
                <a:ext uri="{FF2B5EF4-FFF2-40B4-BE49-F238E27FC236}">
                  <a16:creationId xmlns:a16="http://schemas.microsoft.com/office/drawing/2014/main" id="{3D96D4F2-3459-D83F-AA22-820D97DAB1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1" y="3947"/>
              <a:ext cx="3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" name="Oval 129">
              <a:extLst>
                <a:ext uri="{FF2B5EF4-FFF2-40B4-BE49-F238E27FC236}">
                  <a16:creationId xmlns:a16="http://schemas.microsoft.com/office/drawing/2014/main" id="{99325917-D2D0-D257-FD61-59C86B88DC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1" y="3934"/>
              <a:ext cx="27" cy="26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6" name="Rectangle 130">
              <a:extLst>
                <a:ext uri="{FF2B5EF4-FFF2-40B4-BE49-F238E27FC236}">
                  <a16:creationId xmlns:a16="http://schemas.microsoft.com/office/drawing/2014/main" id="{D178654A-5307-CCFB-4662-7937654B09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4" y="4269"/>
              <a:ext cx="13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" name="Rectangle 131">
              <a:extLst>
                <a:ext uri="{FF2B5EF4-FFF2-40B4-BE49-F238E27FC236}">
                  <a16:creationId xmlns:a16="http://schemas.microsoft.com/office/drawing/2014/main" id="{240C4FB8-B267-E7E0-A0C4-C7718A65CC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4" y="4295"/>
              <a:ext cx="1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" name="Rectangle 132">
              <a:extLst>
                <a:ext uri="{FF2B5EF4-FFF2-40B4-BE49-F238E27FC236}">
                  <a16:creationId xmlns:a16="http://schemas.microsoft.com/office/drawing/2014/main" id="{29EC17AE-7ED4-F0D3-625C-D752CC9F80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9" y="4273"/>
              <a:ext cx="22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" name="Rectangle 133">
              <a:extLst>
                <a:ext uri="{FF2B5EF4-FFF2-40B4-BE49-F238E27FC236}">
                  <a16:creationId xmlns:a16="http://schemas.microsoft.com/office/drawing/2014/main" id="{0F61A548-03AD-3A78-64AC-697DDA5111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9" y="4291"/>
              <a:ext cx="2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" name="Rectangle 134">
              <a:extLst>
                <a:ext uri="{FF2B5EF4-FFF2-40B4-BE49-F238E27FC236}">
                  <a16:creationId xmlns:a16="http://schemas.microsoft.com/office/drawing/2014/main" id="{03214346-A933-588E-83DA-74C45CEBBB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5" y="4278"/>
              <a:ext cx="3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" name="Rectangle 135">
              <a:extLst>
                <a:ext uri="{FF2B5EF4-FFF2-40B4-BE49-F238E27FC236}">
                  <a16:creationId xmlns:a16="http://schemas.microsoft.com/office/drawing/2014/main" id="{8D01AE10-1AB4-0890-3061-A7B6E6A45C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5" y="4286"/>
              <a:ext cx="31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" name="Rectangle 136">
              <a:extLst>
                <a:ext uri="{FF2B5EF4-FFF2-40B4-BE49-F238E27FC236}">
                  <a16:creationId xmlns:a16="http://schemas.microsoft.com/office/drawing/2014/main" id="{DD0A08F7-0811-9772-025F-E1D7BEF89D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5" y="4282"/>
              <a:ext cx="3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3" name="Rectangle 137">
              <a:extLst>
                <a:ext uri="{FF2B5EF4-FFF2-40B4-BE49-F238E27FC236}">
                  <a16:creationId xmlns:a16="http://schemas.microsoft.com/office/drawing/2014/main" id="{F8BEE54D-DCAA-B396-85DD-8134B54DBB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5" y="4282"/>
              <a:ext cx="3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" name="Oval 138">
              <a:extLst>
                <a:ext uri="{FF2B5EF4-FFF2-40B4-BE49-F238E27FC236}">
                  <a16:creationId xmlns:a16="http://schemas.microsoft.com/office/drawing/2014/main" id="{5729A10B-3C69-8D31-C54D-CE85730132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5" y="4269"/>
              <a:ext cx="26" cy="26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" name="Rectangle 139">
              <a:extLst>
                <a:ext uri="{FF2B5EF4-FFF2-40B4-BE49-F238E27FC236}">
                  <a16:creationId xmlns:a16="http://schemas.microsoft.com/office/drawing/2014/main" id="{8F3A0951-B44D-00CD-6713-E9AEEF4C15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5" y="3934"/>
              <a:ext cx="14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" name="Rectangle 140">
              <a:extLst>
                <a:ext uri="{FF2B5EF4-FFF2-40B4-BE49-F238E27FC236}">
                  <a16:creationId xmlns:a16="http://schemas.microsoft.com/office/drawing/2014/main" id="{6735BD51-218F-24F7-8A0E-FC439BE459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5" y="3960"/>
              <a:ext cx="14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" name="Rectangle 141">
              <a:extLst>
                <a:ext uri="{FF2B5EF4-FFF2-40B4-BE49-F238E27FC236}">
                  <a16:creationId xmlns:a16="http://schemas.microsoft.com/office/drawing/2014/main" id="{2954AD13-1779-732C-B93C-96A40E15B1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1" y="3938"/>
              <a:ext cx="2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" name="Rectangle 142">
              <a:extLst>
                <a:ext uri="{FF2B5EF4-FFF2-40B4-BE49-F238E27FC236}">
                  <a16:creationId xmlns:a16="http://schemas.microsoft.com/office/drawing/2014/main" id="{456A05DA-411F-FA5F-63B2-6677AF2036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1" y="3956"/>
              <a:ext cx="2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" name="Rectangle 143">
              <a:extLst>
                <a:ext uri="{FF2B5EF4-FFF2-40B4-BE49-F238E27FC236}">
                  <a16:creationId xmlns:a16="http://schemas.microsoft.com/office/drawing/2014/main" id="{091AF7BA-6128-9F91-6AB3-42AA967BA2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6" y="3942"/>
              <a:ext cx="31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Rectangle 144">
              <a:extLst>
                <a:ext uri="{FF2B5EF4-FFF2-40B4-BE49-F238E27FC236}">
                  <a16:creationId xmlns:a16="http://schemas.microsoft.com/office/drawing/2014/main" id="{0DC3DE5F-7F6C-6ABB-93AB-90C2EF5BA2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6" y="3951"/>
              <a:ext cx="31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" name="Rectangle 145">
              <a:extLst>
                <a:ext uri="{FF2B5EF4-FFF2-40B4-BE49-F238E27FC236}">
                  <a16:creationId xmlns:a16="http://schemas.microsoft.com/office/drawing/2014/main" id="{026240F7-4BD8-2865-85FD-8C1B279429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6" y="3947"/>
              <a:ext cx="3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" name="Rectangle 146">
              <a:extLst>
                <a:ext uri="{FF2B5EF4-FFF2-40B4-BE49-F238E27FC236}">
                  <a16:creationId xmlns:a16="http://schemas.microsoft.com/office/drawing/2014/main" id="{003D3C31-710B-AF21-686F-11C07D3418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6" y="3947"/>
              <a:ext cx="31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3" name="Oval 147">
              <a:extLst>
                <a:ext uri="{FF2B5EF4-FFF2-40B4-BE49-F238E27FC236}">
                  <a16:creationId xmlns:a16="http://schemas.microsoft.com/office/drawing/2014/main" id="{44F263A0-0404-7E12-69E5-8411E4A79B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6" y="3934"/>
              <a:ext cx="27" cy="26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" name="Line 148">
              <a:extLst>
                <a:ext uri="{FF2B5EF4-FFF2-40B4-BE49-F238E27FC236}">
                  <a16:creationId xmlns:a16="http://schemas.microsoft.com/office/drawing/2014/main" id="{D3ABC03C-629C-F3B5-E64E-E986AC80F6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8" y="6055"/>
              <a:ext cx="217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5" name="Line 149">
              <a:extLst>
                <a:ext uri="{FF2B5EF4-FFF2-40B4-BE49-F238E27FC236}">
                  <a16:creationId xmlns:a16="http://schemas.microsoft.com/office/drawing/2014/main" id="{D1F5517B-1265-DC89-0C41-81DA047320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8" y="6055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" name="Line 150">
              <a:extLst>
                <a:ext uri="{FF2B5EF4-FFF2-40B4-BE49-F238E27FC236}">
                  <a16:creationId xmlns:a16="http://schemas.microsoft.com/office/drawing/2014/main" id="{6FB976C1-ADFB-B4F4-ADA9-9D7F56C759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10" y="6055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Line 151">
              <a:extLst>
                <a:ext uri="{FF2B5EF4-FFF2-40B4-BE49-F238E27FC236}">
                  <a16:creationId xmlns:a16="http://schemas.microsoft.com/office/drawing/2014/main" id="{F106572E-31F7-2A39-BDB7-D080562B88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53" y="6055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Line 152">
              <a:extLst>
                <a:ext uri="{FF2B5EF4-FFF2-40B4-BE49-F238E27FC236}">
                  <a16:creationId xmlns:a16="http://schemas.microsoft.com/office/drawing/2014/main" id="{6FD0C991-99C1-0CB7-54E8-E68DB538AB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00" y="6055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" name="Line 153">
              <a:extLst>
                <a:ext uri="{FF2B5EF4-FFF2-40B4-BE49-F238E27FC236}">
                  <a16:creationId xmlns:a16="http://schemas.microsoft.com/office/drawing/2014/main" id="{2EC5F63E-6FBC-8206-13F6-3C97C6F188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42" y="6055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Rectangle 154">
              <a:extLst>
                <a:ext uri="{FF2B5EF4-FFF2-40B4-BE49-F238E27FC236}">
                  <a16:creationId xmlns:a16="http://schemas.microsoft.com/office/drawing/2014/main" id="{2809B24B-5410-457C-7A67-4AC7500A59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5" y="6143"/>
              <a:ext cx="20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2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ectangle 155">
              <a:extLst>
                <a:ext uri="{FF2B5EF4-FFF2-40B4-BE49-F238E27FC236}">
                  <a16:creationId xmlns:a16="http://schemas.microsoft.com/office/drawing/2014/main" id="{9564CDE2-D382-2A2F-57FB-46972BAE24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7" y="6143"/>
              <a:ext cx="20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4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Rectangle 156">
              <a:extLst>
                <a:ext uri="{FF2B5EF4-FFF2-40B4-BE49-F238E27FC236}">
                  <a16:creationId xmlns:a16="http://schemas.microsoft.com/office/drawing/2014/main" id="{B0370641-0561-4D0E-4EF3-901FA95A9B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0" y="6143"/>
              <a:ext cx="20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6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Rectangle 157">
              <a:extLst>
                <a:ext uri="{FF2B5EF4-FFF2-40B4-BE49-F238E27FC236}">
                  <a16:creationId xmlns:a16="http://schemas.microsoft.com/office/drawing/2014/main" id="{589A9490-8C49-22E0-9735-8BAAC463A8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7" y="6143"/>
              <a:ext cx="20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8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Rectangle 158">
              <a:extLst>
                <a:ext uri="{FF2B5EF4-FFF2-40B4-BE49-F238E27FC236}">
                  <a16:creationId xmlns:a16="http://schemas.microsoft.com/office/drawing/2014/main" id="{00A5D73E-E6D1-57DD-DFAB-E93986FFCB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9" y="6143"/>
              <a:ext cx="20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10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Line 159">
              <a:extLst>
                <a:ext uri="{FF2B5EF4-FFF2-40B4-BE49-F238E27FC236}">
                  <a16:creationId xmlns:a16="http://schemas.microsoft.com/office/drawing/2014/main" id="{97BFFFD4-76D4-EE3C-4074-100EB37FFE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87" y="3947"/>
              <a:ext cx="0" cy="202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" name="Line 160">
              <a:extLst>
                <a:ext uri="{FF2B5EF4-FFF2-40B4-BE49-F238E27FC236}">
                  <a16:creationId xmlns:a16="http://schemas.microsoft.com/office/drawing/2014/main" id="{A2678B2A-9A5B-C554-67E3-3BED1BA514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47" y="5971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" name="Line 161">
              <a:extLst>
                <a:ext uri="{FF2B5EF4-FFF2-40B4-BE49-F238E27FC236}">
                  <a16:creationId xmlns:a16="http://schemas.microsoft.com/office/drawing/2014/main" id="{83EEC431-6623-C680-B75C-3031D5D791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47" y="5565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" name="Line 162">
              <a:extLst>
                <a:ext uri="{FF2B5EF4-FFF2-40B4-BE49-F238E27FC236}">
                  <a16:creationId xmlns:a16="http://schemas.microsoft.com/office/drawing/2014/main" id="{9C3A4709-1EA2-1966-B102-D715B117C1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47" y="5160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" name="Line 163">
              <a:extLst>
                <a:ext uri="{FF2B5EF4-FFF2-40B4-BE49-F238E27FC236}">
                  <a16:creationId xmlns:a16="http://schemas.microsoft.com/office/drawing/2014/main" id="{AA6C8AF7-17E8-E0B1-2BBC-B12175AE09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47" y="4754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" name="Line 164">
              <a:extLst>
                <a:ext uri="{FF2B5EF4-FFF2-40B4-BE49-F238E27FC236}">
                  <a16:creationId xmlns:a16="http://schemas.microsoft.com/office/drawing/2014/main" id="{D1EE28D3-EDD9-B71B-F023-76444E8195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47" y="4353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" name="Line 165">
              <a:extLst>
                <a:ext uri="{FF2B5EF4-FFF2-40B4-BE49-F238E27FC236}">
                  <a16:creationId xmlns:a16="http://schemas.microsoft.com/office/drawing/2014/main" id="{263E56EF-5D54-3AAB-573B-5DC882054A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647" y="3947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" name="Rectangle 166">
              <a:extLst>
                <a:ext uri="{FF2B5EF4-FFF2-40B4-BE49-F238E27FC236}">
                  <a16:creationId xmlns:a16="http://schemas.microsoft.com/office/drawing/2014/main" id="{1AB31BCA-0A45-EEA5-90BF-62C2ECC0F6D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15" y="5918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Rectangle 167">
              <a:extLst>
                <a:ext uri="{FF2B5EF4-FFF2-40B4-BE49-F238E27FC236}">
                  <a16:creationId xmlns:a16="http://schemas.microsoft.com/office/drawing/2014/main" id="{F519AA95-B588-60D3-F247-66C438D79CA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15" y="5512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Rectangle 168">
              <a:extLst>
                <a:ext uri="{FF2B5EF4-FFF2-40B4-BE49-F238E27FC236}">
                  <a16:creationId xmlns:a16="http://schemas.microsoft.com/office/drawing/2014/main" id="{92207967-4548-1E11-17F1-A546F13C448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15" y="5107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Rectangle 169">
              <a:extLst>
                <a:ext uri="{FF2B5EF4-FFF2-40B4-BE49-F238E27FC236}">
                  <a16:creationId xmlns:a16="http://schemas.microsoft.com/office/drawing/2014/main" id="{F4B1D97F-50F9-B1F4-FF04-673DF332518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15" y="4701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Rectangle 170">
              <a:extLst>
                <a:ext uri="{FF2B5EF4-FFF2-40B4-BE49-F238E27FC236}">
                  <a16:creationId xmlns:a16="http://schemas.microsoft.com/office/drawing/2014/main" id="{BF5B6394-5990-C78B-EC1A-728D3E9AEEB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15" y="4300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Rectangle 171">
              <a:extLst>
                <a:ext uri="{FF2B5EF4-FFF2-40B4-BE49-F238E27FC236}">
                  <a16:creationId xmlns:a16="http://schemas.microsoft.com/office/drawing/2014/main" id="{C031D016-CD20-FB8F-B6A5-9F5E4F769B1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15" y="3894"/>
              <a:ext cx="11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172">
              <a:extLst>
                <a:ext uri="{FF2B5EF4-FFF2-40B4-BE49-F238E27FC236}">
                  <a16:creationId xmlns:a16="http://schemas.microsoft.com/office/drawing/2014/main" id="{C49E37ED-C9BF-83BF-437A-CB53995913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7" y="3863"/>
              <a:ext cx="2444" cy="2192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" name="Rectangle 174">
              <a:extLst>
                <a:ext uri="{FF2B5EF4-FFF2-40B4-BE49-F238E27FC236}">
                  <a16:creationId xmlns:a16="http://schemas.microsoft.com/office/drawing/2014/main" id="{C4C51561-9DAD-12EA-EF13-90B6392057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4" y="6315"/>
              <a:ext cx="15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/m</a:t>
              </a:r>
              <a:endParaRPr kumimoji="0" lang="ja-JP" altLang="ja-JP" sz="3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Rectangle 175">
              <a:extLst>
                <a:ext uri="{FF2B5EF4-FFF2-40B4-BE49-F238E27FC236}">
                  <a16:creationId xmlns:a16="http://schemas.microsoft.com/office/drawing/2014/main" id="{20C8122F-F6AD-A0D1-660B-8B970CEC95B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913" y="4889"/>
              <a:ext cx="980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portion </a:t>
              </a: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esponding</a:t>
              </a:r>
              <a:endParaRPr kumimoji="0" lang="ja-JP" altLang="ja-JP" sz="3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Freeform 176">
              <a:extLst>
                <a:ext uri="{FF2B5EF4-FFF2-40B4-BE49-F238E27FC236}">
                  <a16:creationId xmlns:a16="http://schemas.microsoft.com/office/drawing/2014/main" id="{47F71ABB-3BB2-5024-0E4E-C43037B7F3AD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0" y="3947"/>
              <a:ext cx="2262" cy="141"/>
            </a:xfrm>
            <a:custGeom>
              <a:avLst/>
              <a:gdLst>
                <a:gd name="T0" fmla="*/ 5 w 513"/>
                <a:gd name="T1" fmla="*/ 30 h 32"/>
                <a:gd name="T2" fmla="*/ 15 w 513"/>
                <a:gd name="T3" fmla="*/ 28 h 32"/>
                <a:gd name="T4" fmla="*/ 26 w 513"/>
                <a:gd name="T5" fmla="*/ 26 h 32"/>
                <a:gd name="T6" fmla="*/ 36 w 513"/>
                <a:gd name="T7" fmla="*/ 23 h 32"/>
                <a:gd name="T8" fmla="*/ 46 w 513"/>
                <a:gd name="T9" fmla="*/ 21 h 32"/>
                <a:gd name="T10" fmla="*/ 57 w 513"/>
                <a:gd name="T11" fmla="*/ 20 h 32"/>
                <a:gd name="T12" fmla="*/ 67 w 513"/>
                <a:gd name="T13" fmla="*/ 18 h 32"/>
                <a:gd name="T14" fmla="*/ 77 w 513"/>
                <a:gd name="T15" fmla="*/ 16 h 32"/>
                <a:gd name="T16" fmla="*/ 88 w 513"/>
                <a:gd name="T17" fmla="*/ 15 h 32"/>
                <a:gd name="T18" fmla="*/ 98 w 513"/>
                <a:gd name="T19" fmla="*/ 13 h 32"/>
                <a:gd name="T20" fmla="*/ 109 w 513"/>
                <a:gd name="T21" fmla="*/ 12 h 32"/>
                <a:gd name="T22" fmla="*/ 119 w 513"/>
                <a:gd name="T23" fmla="*/ 11 h 32"/>
                <a:gd name="T24" fmla="*/ 129 w 513"/>
                <a:gd name="T25" fmla="*/ 10 h 32"/>
                <a:gd name="T26" fmla="*/ 140 w 513"/>
                <a:gd name="T27" fmla="*/ 9 h 32"/>
                <a:gd name="T28" fmla="*/ 150 w 513"/>
                <a:gd name="T29" fmla="*/ 8 h 32"/>
                <a:gd name="T30" fmla="*/ 160 w 513"/>
                <a:gd name="T31" fmla="*/ 7 h 32"/>
                <a:gd name="T32" fmla="*/ 171 w 513"/>
                <a:gd name="T33" fmla="*/ 6 h 32"/>
                <a:gd name="T34" fmla="*/ 181 w 513"/>
                <a:gd name="T35" fmla="*/ 6 h 32"/>
                <a:gd name="T36" fmla="*/ 191 w 513"/>
                <a:gd name="T37" fmla="*/ 5 h 32"/>
                <a:gd name="T38" fmla="*/ 202 w 513"/>
                <a:gd name="T39" fmla="*/ 4 h 32"/>
                <a:gd name="T40" fmla="*/ 212 w 513"/>
                <a:gd name="T41" fmla="*/ 4 h 32"/>
                <a:gd name="T42" fmla="*/ 223 w 513"/>
                <a:gd name="T43" fmla="*/ 3 h 32"/>
                <a:gd name="T44" fmla="*/ 233 w 513"/>
                <a:gd name="T45" fmla="*/ 3 h 32"/>
                <a:gd name="T46" fmla="*/ 243 w 513"/>
                <a:gd name="T47" fmla="*/ 3 h 32"/>
                <a:gd name="T48" fmla="*/ 254 w 513"/>
                <a:gd name="T49" fmla="*/ 2 h 32"/>
                <a:gd name="T50" fmla="*/ 264 w 513"/>
                <a:gd name="T51" fmla="*/ 2 h 32"/>
                <a:gd name="T52" fmla="*/ 274 w 513"/>
                <a:gd name="T53" fmla="*/ 2 h 32"/>
                <a:gd name="T54" fmla="*/ 285 w 513"/>
                <a:gd name="T55" fmla="*/ 1 h 32"/>
                <a:gd name="T56" fmla="*/ 295 w 513"/>
                <a:gd name="T57" fmla="*/ 1 h 32"/>
                <a:gd name="T58" fmla="*/ 305 w 513"/>
                <a:gd name="T59" fmla="*/ 1 h 32"/>
                <a:gd name="T60" fmla="*/ 316 w 513"/>
                <a:gd name="T61" fmla="*/ 1 h 32"/>
                <a:gd name="T62" fmla="*/ 326 w 513"/>
                <a:gd name="T63" fmla="*/ 1 h 32"/>
                <a:gd name="T64" fmla="*/ 337 w 513"/>
                <a:gd name="T65" fmla="*/ 1 h 32"/>
                <a:gd name="T66" fmla="*/ 347 w 513"/>
                <a:gd name="T67" fmla="*/ 0 h 32"/>
                <a:gd name="T68" fmla="*/ 357 w 513"/>
                <a:gd name="T69" fmla="*/ 0 h 32"/>
                <a:gd name="T70" fmla="*/ 368 w 513"/>
                <a:gd name="T71" fmla="*/ 0 h 32"/>
                <a:gd name="T72" fmla="*/ 378 w 513"/>
                <a:gd name="T73" fmla="*/ 0 h 32"/>
                <a:gd name="T74" fmla="*/ 388 w 513"/>
                <a:gd name="T75" fmla="*/ 0 h 32"/>
                <a:gd name="T76" fmla="*/ 399 w 513"/>
                <a:gd name="T77" fmla="*/ 0 h 32"/>
                <a:gd name="T78" fmla="*/ 409 w 513"/>
                <a:gd name="T79" fmla="*/ 0 h 32"/>
                <a:gd name="T80" fmla="*/ 419 w 513"/>
                <a:gd name="T81" fmla="*/ 0 h 32"/>
                <a:gd name="T82" fmla="*/ 430 w 513"/>
                <a:gd name="T83" fmla="*/ 0 h 32"/>
                <a:gd name="T84" fmla="*/ 440 w 513"/>
                <a:gd name="T85" fmla="*/ 0 h 32"/>
                <a:gd name="T86" fmla="*/ 450 w 513"/>
                <a:gd name="T87" fmla="*/ 0 h 32"/>
                <a:gd name="T88" fmla="*/ 461 w 513"/>
                <a:gd name="T89" fmla="*/ 0 h 32"/>
                <a:gd name="T90" fmla="*/ 471 w 513"/>
                <a:gd name="T91" fmla="*/ 0 h 32"/>
                <a:gd name="T92" fmla="*/ 482 w 513"/>
                <a:gd name="T93" fmla="*/ 0 h 32"/>
                <a:gd name="T94" fmla="*/ 492 w 513"/>
                <a:gd name="T95" fmla="*/ 0 h 32"/>
                <a:gd name="T96" fmla="*/ 502 w 513"/>
                <a:gd name="T97" fmla="*/ 0 h 32"/>
                <a:gd name="T98" fmla="*/ 513 w 513"/>
                <a:gd name="T9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513" h="32">
                  <a:moveTo>
                    <a:pt x="0" y="32"/>
                  </a:moveTo>
                  <a:lnTo>
                    <a:pt x="5" y="30"/>
                  </a:lnTo>
                  <a:lnTo>
                    <a:pt x="10" y="29"/>
                  </a:lnTo>
                  <a:lnTo>
                    <a:pt x="15" y="28"/>
                  </a:lnTo>
                  <a:lnTo>
                    <a:pt x="20" y="27"/>
                  </a:lnTo>
                  <a:lnTo>
                    <a:pt x="26" y="26"/>
                  </a:lnTo>
                  <a:lnTo>
                    <a:pt x="31" y="24"/>
                  </a:lnTo>
                  <a:lnTo>
                    <a:pt x="36" y="23"/>
                  </a:lnTo>
                  <a:lnTo>
                    <a:pt x="41" y="22"/>
                  </a:lnTo>
                  <a:lnTo>
                    <a:pt x="46" y="21"/>
                  </a:lnTo>
                  <a:lnTo>
                    <a:pt x="52" y="20"/>
                  </a:lnTo>
                  <a:lnTo>
                    <a:pt x="57" y="20"/>
                  </a:lnTo>
                  <a:lnTo>
                    <a:pt x="62" y="19"/>
                  </a:lnTo>
                  <a:lnTo>
                    <a:pt x="67" y="18"/>
                  </a:lnTo>
                  <a:lnTo>
                    <a:pt x="72" y="17"/>
                  </a:lnTo>
                  <a:lnTo>
                    <a:pt x="77" y="16"/>
                  </a:lnTo>
                  <a:lnTo>
                    <a:pt x="83" y="15"/>
                  </a:lnTo>
                  <a:lnTo>
                    <a:pt x="88" y="15"/>
                  </a:lnTo>
                  <a:lnTo>
                    <a:pt x="93" y="14"/>
                  </a:lnTo>
                  <a:lnTo>
                    <a:pt x="98" y="13"/>
                  </a:lnTo>
                  <a:lnTo>
                    <a:pt x="103" y="13"/>
                  </a:lnTo>
                  <a:lnTo>
                    <a:pt x="109" y="12"/>
                  </a:lnTo>
                  <a:lnTo>
                    <a:pt x="114" y="11"/>
                  </a:lnTo>
                  <a:lnTo>
                    <a:pt x="119" y="11"/>
                  </a:lnTo>
                  <a:lnTo>
                    <a:pt x="124" y="10"/>
                  </a:lnTo>
                  <a:lnTo>
                    <a:pt x="129" y="10"/>
                  </a:lnTo>
                  <a:lnTo>
                    <a:pt x="134" y="9"/>
                  </a:lnTo>
                  <a:lnTo>
                    <a:pt x="140" y="9"/>
                  </a:lnTo>
                  <a:lnTo>
                    <a:pt x="145" y="8"/>
                  </a:lnTo>
                  <a:lnTo>
                    <a:pt x="150" y="8"/>
                  </a:lnTo>
                  <a:lnTo>
                    <a:pt x="155" y="7"/>
                  </a:lnTo>
                  <a:lnTo>
                    <a:pt x="160" y="7"/>
                  </a:lnTo>
                  <a:lnTo>
                    <a:pt x="166" y="7"/>
                  </a:lnTo>
                  <a:lnTo>
                    <a:pt x="171" y="6"/>
                  </a:lnTo>
                  <a:lnTo>
                    <a:pt x="176" y="6"/>
                  </a:lnTo>
                  <a:lnTo>
                    <a:pt x="181" y="6"/>
                  </a:lnTo>
                  <a:lnTo>
                    <a:pt x="186" y="5"/>
                  </a:lnTo>
                  <a:lnTo>
                    <a:pt x="191" y="5"/>
                  </a:lnTo>
                  <a:lnTo>
                    <a:pt x="197" y="5"/>
                  </a:lnTo>
                  <a:lnTo>
                    <a:pt x="202" y="4"/>
                  </a:lnTo>
                  <a:lnTo>
                    <a:pt x="207" y="4"/>
                  </a:lnTo>
                  <a:lnTo>
                    <a:pt x="212" y="4"/>
                  </a:lnTo>
                  <a:lnTo>
                    <a:pt x="217" y="4"/>
                  </a:lnTo>
                  <a:lnTo>
                    <a:pt x="223" y="3"/>
                  </a:lnTo>
                  <a:lnTo>
                    <a:pt x="228" y="3"/>
                  </a:lnTo>
                  <a:lnTo>
                    <a:pt x="233" y="3"/>
                  </a:lnTo>
                  <a:lnTo>
                    <a:pt x="238" y="3"/>
                  </a:lnTo>
                  <a:lnTo>
                    <a:pt x="243" y="3"/>
                  </a:lnTo>
                  <a:lnTo>
                    <a:pt x="248" y="2"/>
                  </a:lnTo>
                  <a:lnTo>
                    <a:pt x="254" y="2"/>
                  </a:lnTo>
                  <a:lnTo>
                    <a:pt x="259" y="2"/>
                  </a:lnTo>
                  <a:lnTo>
                    <a:pt x="264" y="2"/>
                  </a:lnTo>
                  <a:lnTo>
                    <a:pt x="269" y="2"/>
                  </a:lnTo>
                  <a:lnTo>
                    <a:pt x="274" y="2"/>
                  </a:lnTo>
                  <a:lnTo>
                    <a:pt x="280" y="2"/>
                  </a:lnTo>
                  <a:lnTo>
                    <a:pt x="285" y="1"/>
                  </a:lnTo>
                  <a:lnTo>
                    <a:pt x="290" y="1"/>
                  </a:lnTo>
                  <a:lnTo>
                    <a:pt x="295" y="1"/>
                  </a:lnTo>
                  <a:lnTo>
                    <a:pt x="300" y="1"/>
                  </a:lnTo>
                  <a:lnTo>
                    <a:pt x="305" y="1"/>
                  </a:lnTo>
                  <a:lnTo>
                    <a:pt x="311" y="1"/>
                  </a:lnTo>
                  <a:lnTo>
                    <a:pt x="316" y="1"/>
                  </a:lnTo>
                  <a:lnTo>
                    <a:pt x="321" y="1"/>
                  </a:lnTo>
                  <a:lnTo>
                    <a:pt x="326" y="1"/>
                  </a:lnTo>
                  <a:lnTo>
                    <a:pt x="331" y="1"/>
                  </a:lnTo>
                  <a:lnTo>
                    <a:pt x="337" y="1"/>
                  </a:lnTo>
                  <a:lnTo>
                    <a:pt x="342" y="1"/>
                  </a:lnTo>
                  <a:lnTo>
                    <a:pt x="347" y="0"/>
                  </a:lnTo>
                  <a:lnTo>
                    <a:pt x="352" y="0"/>
                  </a:lnTo>
                  <a:lnTo>
                    <a:pt x="357" y="0"/>
                  </a:lnTo>
                  <a:lnTo>
                    <a:pt x="362" y="0"/>
                  </a:lnTo>
                  <a:lnTo>
                    <a:pt x="368" y="0"/>
                  </a:lnTo>
                  <a:lnTo>
                    <a:pt x="373" y="0"/>
                  </a:lnTo>
                  <a:lnTo>
                    <a:pt x="378" y="0"/>
                  </a:lnTo>
                  <a:lnTo>
                    <a:pt x="383" y="0"/>
                  </a:lnTo>
                  <a:lnTo>
                    <a:pt x="388" y="0"/>
                  </a:lnTo>
                  <a:lnTo>
                    <a:pt x="393" y="0"/>
                  </a:lnTo>
                  <a:lnTo>
                    <a:pt x="399" y="0"/>
                  </a:lnTo>
                  <a:lnTo>
                    <a:pt x="404" y="0"/>
                  </a:lnTo>
                  <a:lnTo>
                    <a:pt x="409" y="0"/>
                  </a:lnTo>
                  <a:lnTo>
                    <a:pt x="414" y="0"/>
                  </a:lnTo>
                  <a:lnTo>
                    <a:pt x="419" y="0"/>
                  </a:lnTo>
                  <a:lnTo>
                    <a:pt x="425" y="0"/>
                  </a:lnTo>
                  <a:lnTo>
                    <a:pt x="430" y="0"/>
                  </a:lnTo>
                  <a:lnTo>
                    <a:pt x="435" y="0"/>
                  </a:lnTo>
                  <a:lnTo>
                    <a:pt x="440" y="0"/>
                  </a:lnTo>
                  <a:lnTo>
                    <a:pt x="445" y="0"/>
                  </a:lnTo>
                  <a:lnTo>
                    <a:pt x="450" y="0"/>
                  </a:lnTo>
                  <a:lnTo>
                    <a:pt x="456" y="0"/>
                  </a:lnTo>
                  <a:lnTo>
                    <a:pt x="461" y="0"/>
                  </a:lnTo>
                  <a:lnTo>
                    <a:pt x="466" y="0"/>
                  </a:lnTo>
                  <a:lnTo>
                    <a:pt x="471" y="0"/>
                  </a:lnTo>
                  <a:lnTo>
                    <a:pt x="476" y="0"/>
                  </a:lnTo>
                  <a:lnTo>
                    <a:pt x="482" y="0"/>
                  </a:lnTo>
                  <a:lnTo>
                    <a:pt x="487" y="0"/>
                  </a:lnTo>
                  <a:lnTo>
                    <a:pt x="492" y="0"/>
                  </a:lnTo>
                  <a:lnTo>
                    <a:pt x="497" y="0"/>
                  </a:lnTo>
                  <a:lnTo>
                    <a:pt x="502" y="0"/>
                  </a:lnTo>
                  <a:lnTo>
                    <a:pt x="507" y="0"/>
                  </a:lnTo>
                  <a:lnTo>
                    <a:pt x="513" y="0"/>
                  </a:lnTo>
                </a:path>
              </a:pathLst>
            </a:cu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" name="Rectangle 177">
              <a:extLst>
                <a:ext uri="{FF2B5EF4-FFF2-40B4-BE49-F238E27FC236}">
                  <a16:creationId xmlns:a16="http://schemas.microsoft.com/office/drawing/2014/main" id="{D8FF5F63-5146-E5DE-DF6A-390F53F57C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9" y="4143"/>
              <a:ext cx="1656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it(p) = 1.06 + 252.46 * 1/m</a:t>
              </a:r>
              <a:endParaRPr kumimoji="0" lang="ja-JP" altLang="ja-JP" sz="4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Freeform 178">
              <a:extLst>
                <a:ext uri="{FF2B5EF4-FFF2-40B4-BE49-F238E27FC236}">
                  <a16:creationId xmlns:a16="http://schemas.microsoft.com/office/drawing/2014/main" id="{4D6E5B5D-0F06-6DF0-ACBC-6711793A16C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868" y="3863"/>
              <a:ext cx="0" cy="2187"/>
            </a:xfrm>
            <a:custGeom>
              <a:avLst/>
              <a:gdLst>
                <a:gd name="T0" fmla="*/ 489 h 496"/>
                <a:gd name="T1" fmla="*/ 481 h 496"/>
                <a:gd name="T2" fmla="*/ 473 h 496"/>
                <a:gd name="T3" fmla="*/ 465 h 496"/>
                <a:gd name="T4" fmla="*/ 457 h 496"/>
                <a:gd name="T5" fmla="*/ 449 h 496"/>
                <a:gd name="T6" fmla="*/ 441 h 496"/>
                <a:gd name="T7" fmla="*/ 433 h 496"/>
                <a:gd name="T8" fmla="*/ 425 h 496"/>
                <a:gd name="T9" fmla="*/ 417 h 496"/>
                <a:gd name="T10" fmla="*/ 409 h 496"/>
                <a:gd name="T11" fmla="*/ 401 h 496"/>
                <a:gd name="T12" fmla="*/ 393 h 496"/>
                <a:gd name="T13" fmla="*/ 385 h 496"/>
                <a:gd name="T14" fmla="*/ 377 h 496"/>
                <a:gd name="T15" fmla="*/ 369 h 496"/>
                <a:gd name="T16" fmla="*/ 361 h 496"/>
                <a:gd name="T17" fmla="*/ 353 h 496"/>
                <a:gd name="T18" fmla="*/ 345 h 496"/>
                <a:gd name="T19" fmla="*/ 337 h 496"/>
                <a:gd name="T20" fmla="*/ 329 h 496"/>
                <a:gd name="T21" fmla="*/ 321 h 496"/>
                <a:gd name="T22" fmla="*/ 313 h 496"/>
                <a:gd name="T23" fmla="*/ 305 h 496"/>
                <a:gd name="T24" fmla="*/ 297 h 496"/>
                <a:gd name="T25" fmla="*/ 289 h 496"/>
                <a:gd name="T26" fmla="*/ 281 h 496"/>
                <a:gd name="T27" fmla="*/ 273 h 496"/>
                <a:gd name="T28" fmla="*/ 265 h 496"/>
                <a:gd name="T29" fmla="*/ 257 h 496"/>
                <a:gd name="T30" fmla="*/ 249 h 496"/>
                <a:gd name="T31" fmla="*/ 241 h 496"/>
                <a:gd name="T32" fmla="*/ 233 h 496"/>
                <a:gd name="T33" fmla="*/ 225 h 496"/>
                <a:gd name="T34" fmla="*/ 217 h 496"/>
                <a:gd name="T35" fmla="*/ 209 h 496"/>
                <a:gd name="T36" fmla="*/ 201 h 496"/>
                <a:gd name="T37" fmla="*/ 193 h 496"/>
                <a:gd name="T38" fmla="*/ 185 h 496"/>
                <a:gd name="T39" fmla="*/ 177 h 496"/>
                <a:gd name="T40" fmla="*/ 169 h 496"/>
                <a:gd name="T41" fmla="*/ 161 h 496"/>
                <a:gd name="T42" fmla="*/ 153 h 496"/>
                <a:gd name="T43" fmla="*/ 145 h 496"/>
                <a:gd name="T44" fmla="*/ 137 h 496"/>
                <a:gd name="T45" fmla="*/ 129 h 496"/>
                <a:gd name="T46" fmla="*/ 121 h 496"/>
                <a:gd name="T47" fmla="*/ 113 h 496"/>
                <a:gd name="T48" fmla="*/ 105 h 496"/>
                <a:gd name="T49" fmla="*/ 97 h 496"/>
                <a:gd name="T50" fmla="*/ 89 h 496"/>
                <a:gd name="T51" fmla="*/ 81 h 496"/>
                <a:gd name="T52" fmla="*/ 73 h 496"/>
                <a:gd name="T53" fmla="*/ 65 h 496"/>
                <a:gd name="T54" fmla="*/ 57 h 496"/>
                <a:gd name="T55" fmla="*/ 49 h 496"/>
                <a:gd name="T56" fmla="*/ 41 h 496"/>
                <a:gd name="T57" fmla="*/ 33 h 496"/>
                <a:gd name="T58" fmla="*/ 25 h 496"/>
                <a:gd name="T59" fmla="*/ 17 h 496"/>
                <a:gd name="T60" fmla="*/ 9 h 496"/>
                <a:gd name="T61" fmla="*/ 1 h 4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  <a:cxn ang="0">
                  <a:pos x="0" y="T61"/>
                </a:cxn>
              </a:cxnLst>
              <a:rect l="0" t="0" r="r" b="b"/>
              <a:pathLst>
                <a:path h="496"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" name="Freeform 179">
              <a:extLst>
                <a:ext uri="{FF2B5EF4-FFF2-40B4-BE49-F238E27FC236}">
                  <a16:creationId xmlns:a16="http://schemas.microsoft.com/office/drawing/2014/main" id="{5BCBF6C8-3B35-64B9-D61E-F3C19929CF5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410" y="3863"/>
              <a:ext cx="0" cy="2187"/>
            </a:xfrm>
            <a:custGeom>
              <a:avLst/>
              <a:gdLst>
                <a:gd name="T0" fmla="*/ 489 h 496"/>
                <a:gd name="T1" fmla="*/ 481 h 496"/>
                <a:gd name="T2" fmla="*/ 473 h 496"/>
                <a:gd name="T3" fmla="*/ 465 h 496"/>
                <a:gd name="T4" fmla="*/ 457 h 496"/>
                <a:gd name="T5" fmla="*/ 449 h 496"/>
                <a:gd name="T6" fmla="*/ 441 h 496"/>
                <a:gd name="T7" fmla="*/ 433 h 496"/>
                <a:gd name="T8" fmla="*/ 425 h 496"/>
                <a:gd name="T9" fmla="*/ 417 h 496"/>
                <a:gd name="T10" fmla="*/ 409 h 496"/>
                <a:gd name="T11" fmla="*/ 401 h 496"/>
                <a:gd name="T12" fmla="*/ 393 h 496"/>
                <a:gd name="T13" fmla="*/ 385 h 496"/>
                <a:gd name="T14" fmla="*/ 377 h 496"/>
                <a:gd name="T15" fmla="*/ 369 h 496"/>
                <a:gd name="T16" fmla="*/ 361 h 496"/>
                <a:gd name="T17" fmla="*/ 353 h 496"/>
                <a:gd name="T18" fmla="*/ 345 h 496"/>
                <a:gd name="T19" fmla="*/ 337 h 496"/>
                <a:gd name="T20" fmla="*/ 329 h 496"/>
                <a:gd name="T21" fmla="*/ 321 h 496"/>
                <a:gd name="T22" fmla="*/ 313 h 496"/>
                <a:gd name="T23" fmla="*/ 305 h 496"/>
                <a:gd name="T24" fmla="*/ 297 h 496"/>
                <a:gd name="T25" fmla="*/ 289 h 496"/>
                <a:gd name="T26" fmla="*/ 281 h 496"/>
                <a:gd name="T27" fmla="*/ 273 h 496"/>
                <a:gd name="T28" fmla="*/ 265 h 496"/>
                <a:gd name="T29" fmla="*/ 257 h 496"/>
                <a:gd name="T30" fmla="*/ 249 h 496"/>
                <a:gd name="T31" fmla="*/ 241 h 496"/>
                <a:gd name="T32" fmla="*/ 233 h 496"/>
                <a:gd name="T33" fmla="*/ 225 h 496"/>
                <a:gd name="T34" fmla="*/ 217 h 496"/>
                <a:gd name="T35" fmla="*/ 209 h 496"/>
                <a:gd name="T36" fmla="*/ 201 h 496"/>
                <a:gd name="T37" fmla="*/ 193 h 496"/>
                <a:gd name="T38" fmla="*/ 185 h 496"/>
                <a:gd name="T39" fmla="*/ 177 h 496"/>
                <a:gd name="T40" fmla="*/ 169 h 496"/>
                <a:gd name="T41" fmla="*/ 161 h 496"/>
                <a:gd name="T42" fmla="*/ 153 h 496"/>
                <a:gd name="T43" fmla="*/ 145 h 496"/>
                <a:gd name="T44" fmla="*/ 137 h 496"/>
                <a:gd name="T45" fmla="*/ 129 h 496"/>
                <a:gd name="T46" fmla="*/ 121 h 496"/>
                <a:gd name="T47" fmla="*/ 113 h 496"/>
                <a:gd name="T48" fmla="*/ 105 h 496"/>
                <a:gd name="T49" fmla="*/ 97 h 496"/>
                <a:gd name="T50" fmla="*/ 89 h 496"/>
                <a:gd name="T51" fmla="*/ 81 h 496"/>
                <a:gd name="T52" fmla="*/ 73 h 496"/>
                <a:gd name="T53" fmla="*/ 65 h 496"/>
                <a:gd name="T54" fmla="*/ 57 h 496"/>
                <a:gd name="T55" fmla="*/ 49 h 496"/>
                <a:gd name="T56" fmla="*/ 41 h 496"/>
                <a:gd name="T57" fmla="*/ 33 h 496"/>
                <a:gd name="T58" fmla="*/ 25 h 496"/>
                <a:gd name="T59" fmla="*/ 17 h 496"/>
                <a:gd name="T60" fmla="*/ 9 h 496"/>
                <a:gd name="T61" fmla="*/ 1 h 4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  <a:cxn ang="0">
                  <a:pos x="0" y="T61"/>
                </a:cxn>
              </a:cxnLst>
              <a:rect l="0" t="0" r="r" b="b"/>
              <a:pathLst>
                <a:path h="496"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6" name="Freeform 180">
              <a:extLst>
                <a:ext uri="{FF2B5EF4-FFF2-40B4-BE49-F238E27FC236}">
                  <a16:creationId xmlns:a16="http://schemas.microsoft.com/office/drawing/2014/main" id="{1A7C52E4-8436-033C-8779-559C20FAF9C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953" y="3863"/>
              <a:ext cx="0" cy="2187"/>
            </a:xfrm>
            <a:custGeom>
              <a:avLst/>
              <a:gdLst>
                <a:gd name="T0" fmla="*/ 489 h 496"/>
                <a:gd name="T1" fmla="*/ 481 h 496"/>
                <a:gd name="T2" fmla="*/ 473 h 496"/>
                <a:gd name="T3" fmla="*/ 465 h 496"/>
                <a:gd name="T4" fmla="*/ 457 h 496"/>
                <a:gd name="T5" fmla="*/ 449 h 496"/>
                <a:gd name="T6" fmla="*/ 441 h 496"/>
                <a:gd name="T7" fmla="*/ 433 h 496"/>
                <a:gd name="T8" fmla="*/ 425 h 496"/>
                <a:gd name="T9" fmla="*/ 417 h 496"/>
                <a:gd name="T10" fmla="*/ 409 h 496"/>
                <a:gd name="T11" fmla="*/ 401 h 496"/>
                <a:gd name="T12" fmla="*/ 393 h 496"/>
                <a:gd name="T13" fmla="*/ 385 h 496"/>
                <a:gd name="T14" fmla="*/ 377 h 496"/>
                <a:gd name="T15" fmla="*/ 369 h 496"/>
                <a:gd name="T16" fmla="*/ 361 h 496"/>
                <a:gd name="T17" fmla="*/ 353 h 496"/>
                <a:gd name="T18" fmla="*/ 345 h 496"/>
                <a:gd name="T19" fmla="*/ 337 h 496"/>
                <a:gd name="T20" fmla="*/ 329 h 496"/>
                <a:gd name="T21" fmla="*/ 321 h 496"/>
                <a:gd name="T22" fmla="*/ 313 h 496"/>
                <a:gd name="T23" fmla="*/ 305 h 496"/>
                <a:gd name="T24" fmla="*/ 297 h 496"/>
                <a:gd name="T25" fmla="*/ 289 h 496"/>
                <a:gd name="T26" fmla="*/ 281 h 496"/>
                <a:gd name="T27" fmla="*/ 273 h 496"/>
                <a:gd name="T28" fmla="*/ 265 h 496"/>
                <a:gd name="T29" fmla="*/ 257 h 496"/>
                <a:gd name="T30" fmla="*/ 249 h 496"/>
                <a:gd name="T31" fmla="*/ 241 h 496"/>
                <a:gd name="T32" fmla="*/ 233 h 496"/>
                <a:gd name="T33" fmla="*/ 225 h 496"/>
                <a:gd name="T34" fmla="*/ 217 h 496"/>
                <a:gd name="T35" fmla="*/ 209 h 496"/>
                <a:gd name="T36" fmla="*/ 201 h 496"/>
                <a:gd name="T37" fmla="*/ 193 h 496"/>
                <a:gd name="T38" fmla="*/ 185 h 496"/>
                <a:gd name="T39" fmla="*/ 177 h 496"/>
                <a:gd name="T40" fmla="*/ 169 h 496"/>
                <a:gd name="T41" fmla="*/ 161 h 496"/>
                <a:gd name="T42" fmla="*/ 153 h 496"/>
                <a:gd name="T43" fmla="*/ 145 h 496"/>
                <a:gd name="T44" fmla="*/ 137 h 496"/>
                <a:gd name="T45" fmla="*/ 129 h 496"/>
                <a:gd name="T46" fmla="*/ 121 h 496"/>
                <a:gd name="T47" fmla="*/ 113 h 496"/>
                <a:gd name="T48" fmla="*/ 105 h 496"/>
                <a:gd name="T49" fmla="*/ 97 h 496"/>
                <a:gd name="T50" fmla="*/ 89 h 496"/>
                <a:gd name="T51" fmla="*/ 81 h 496"/>
                <a:gd name="T52" fmla="*/ 73 h 496"/>
                <a:gd name="T53" fmla="*/ 65 h 496"/>
                <a:gd name="T54" fmla="*/ 57 h 496"/>
                <a:gd name="T55" fmla="*/ 49 h 496"/>
                <a:gd name="T56" fmla="*/ 41 h 496"/>
                <a:gd name="T57" fmla="*/ 33 h 496"/>
                <a:gd name="T58" fmla="*/ 25 h 496"/>
                <a:gd name="T59" fmla="*/ 17 h 496"/>
                <a:gd name="T60" fmla="*/ 9 h 496"/>
                <a:gd name="T61" fmla="*/ 1 h 4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  <a:cxn ang="0">
                  <a:pos x="0" y="T61"/>
                </a:cxn>
              </a:cxnLst>
              <a:rect l="0" t="0" r="r" b="b"/>
              <a:pathLst>
                <a:path h="496"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7" name="Freeform 181">
              <a:extLst>
                <a:ext uri="{FF2B5EF4-FFF2-40B4-BE49-F238E27FC236}">
                  <a16:creationId xmlns:a16="http://schemas.microsoft.com/office/drawing/2014/main" id="{80ECC1DE-A002-82FC-AF2C-C3D183558BB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500" y="3863"/>
              <a:ext cx="0" cy="2187"/>
            </a:xfrm>
            <a:custGeom>
              <a:avLst/>
              <a:gdLst>
                <a:gd name="T0" fmla="*/ 489 h 496"/>
                <a:gd name="T1" fmla="*/ 481 h 496"/>
                <a:gd name="T2" fmla="*/ 473 h 496"/>
                <a:gd name="T3" fmla="*/ 465 h 496"/>
                <a:gd name="T4" fmla="*/ 457 h 496"/>
                <a:gd name="T5" fmla="*/ 449 h 496"/>
                <a:gd name="T6" fmla="*/ 441 h 496"/>
                <a:gd name="T7" fmla="*/ 433 h 496"/>
                <a:gd name="T8" fmla="*/ 425 h 496"/>
                <a:gd name="T9" fmla="*/ 417 h 496"/>
                <a:gd name="T10" fmla="*/ 409 h 496"/>
                <a:gd name="T11" fmla="*/ 401 h 496"/>
                <a:gd name="T12" fmla="*/ 393 h 496"/>
                <a:gd name="T13" fmla="*/ 385 h 496"/>
                <a:gd name="T14" fmla="*/ 377 h 496"/>
                <a:gd name="T15" fmla="*/ 369 h 496"/>
                <a:gd name="T16" fmla="*/ 361 h 496"/>
                <a:gd name="T17" fmla="*/ 353 h 496"/>
                <a:gd name="T18" fmla="*/ 345 h 496"/>
                <a:gd name="T19" fmla="*/ 337 h 496"/>
                <a:gd name="T20" fmla="*/ 329 h 496"/>
                <a:gd name="T21" fmla="*/ 321 h 496"/>
                <a:gd name="T22" fmla="*/ 313 h 496"/>
                <a:gd name="T23" fmla="*/ 305 h 496"/>
                <a:gd name="T24" fmla="*/ 297 h 496"/>
                <a:gd name="T25" fmla="*/ 289 h 496"/>
                <a:gd name="T26" fmla="*/ 281 h 496"/>
                <a:gd name="T27" fmla="*/ 273 h 496"/>
                <a:gd name="T28" fmla="*/ 265 h 496"/>
                <a:gd name="T29" fmla="*/ 257 h 496"/>
                <a:gd name="T30" fmla="*/ 249 h 496"/>
                <a:gd name="T31" fmla="*/ 241 h 496"/>
                <a:gd name="T32" fmla="*/ 233 h 496"/>
                <a:gd name="T33" fmla="*/ 225 h 496"/>
                <a:gd name="T34" fmla="*/ 217 h 496"/>
                <a:gd name="T35" fmla="*/ 209 h 496"/>
                <a:gd name="T36" fmla="*/ 201 h 496"/>
                <a:gd name="T37" fmla="*/ 193 h 496"/>
                <a:gd name="T38" fmla="*/ 185 h 496"/>
                <a:gd name="T39" fmla="*/ 177 h 496"/>
                <a:gd name="T40" fmla="*/ 169 h 496"/>
                <a:gd name="T41" fmla="*/ 161 h 496"/>
                <a:gd name="T42" fmla="*/ 153 h 496"/>
                <a:gd name="T43" fmla="*/ 145 h 496"/>
                <a:gd name="T44" fmla="*/ 137 h 496"/>
                <a:gd name="T45" fmla="*/ 129 h 496"/>
                <a:gd name="T46" fmla="*/ 121 h 496"/>
                <a:gd name="T47" fmla="*/ 113 h 496"/>
                <a:gd name="T48" fmla="*/ 105 h 496"/>
                <a:gd name="T49" fmla="*/ 97 h 496"/>
                <a:gd name="T50" fmla="*/ 89 h 496"/>
                <a:gd name="T51" fmla="*/ 81 h 496"/>
                <a:gd name="T52" fmla="*/ 73 h 496"/>
                <a:gd name="T53" fmla="*/ 65 h 496"/>
                <a:gd name="T54" fmla="*/ 57 h 496"/>
                <a:gd name="T55" fmla="*/ 49 h 496"/>
                <a:gd name="T56" fmla="*/ 41 h 496"/>
                <a:gd name="T57" fmla="*/ 33 h 496"/>
                <a:gd name="T58" fmla="*/ 25 h 496"/>
                <a:gd name="T59" fmla="*/ 17 h 496"/>
                <a:gd name="T60" fmla="*/ 9 h 496"/>
                <a:gd name="T61" fmla="*/ 1 h 4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  <a:cxn ang="0">
                  <a:pos x="0" y="T61"/>
                </a:cxn>
              </a:cxnLst>
              <a:rect l="0" t="0" r="r" b="b"/>
              <a:pathLst>
                <a:path h="496"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8" name="Freeform 182">
              <a:extLst>
                <a:ext uri="{FF2B5EF4-FFF2-40B4-BE49-F238E27FC236}">
                  <a16:creationId xmlns:a16="http://schemas.microsoft.com/office/drawing/2014/main" id="{BCA11E60-D866-0806-F7A1-46088D9375D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042" y="3863"/>
              <a:ext cx="0" cy="2187"/>
            </a:xfrm>
            <a:custGeom>
              <a:avLst/>
              <a:gdLst>
                <a:gd name="T0" fmla="*/ 489 h 496"/>
                <a:gd name="T1" fmla="*/ 481 h 496"/>
                <a:gd name="T2" fmla="*/ 473 h 496"/>
                <a:gd name="T3" fmla="*/ 465 h 496"/>
                <a:gd name="T4" fmla="*/ 457 h 496"/>
                <a:gd name="T5" fmla="*/ 449 h 496"/>
                <a:gd name="T6" fmla="*/ 441 h 496"/>
                <a:gd name="T7" fmla="*/ 433 h 496"/>
                <a:gd name="T8" fmla="*/ 425 h 496"/>
                <a:gd name="T9" fmla="*/ 417 h 496"/>
                <a:gd name="T10" fmla="*/ 409 h 496"/>
                <a:gd name="T11" fmla="*/ 401 h 496"/>
                <a:gd name="T12" fmla="*/ 393 h 496"/>
                <a:gd name="T13" fmla="*/ 385 h 496"/>
                <a:gd name="T14" fmla="*/ 377 h 496"/>
                <a:gd name="T15" fmla="*/ 369 h 496"/>
                <a:gd name="T16" fmla="*/ 361 h 496"/>
                <a:gd name="T17" fmla="*/ 353 h 496"/>
                <a:gd name="T18" fmla="*/ 345 h 496"/>
                <a:gd name="T19" fmla="*/ 337 h 496"/>
                <a:gd name="T20" fmla="*/ 329 h 496"/>
                <a:gd name="T21" fmla="*/ 321 h 496"/>
                <a:gd name="T22" fmla="*/ 313 h 496"/>
                <a:gd name="T23" fmla="*/ 305 h 496"/>
                <a:gd name="T24" fmla="*/ 297 h 496"/>
                <a:gd name="T25" fmla="*/ 289 h 496"/>
                <a:gd name="T26" fmla="*/ 281 h 496"/>
                <a:gd name="T27" fmla="*/ 273 h 496"/>
                <a:gd name="T28" fmla="*/ 265 h 496"/>
                <a:gd name="T29" fmla="*/ 257 h 496"/>
                <a:gd name="T30" fmla="*/ 249 h 496"/>
                <a:gd name="T31" fmla="*/ 241 h 496"/>
                <a:gd name="T32" fmla="*/ 233 h 496"/>
                <a:gd name="T33" fmla="*/ 225 h 496"/>
                <a:gd name="T34" fmla="*/ 217 h 496"/>
                <a:gd name="T35" fmla="*/ 209 h 496"/>
                <a:gd name="T36" fmla="*/ 201 h 496"/>
                <a:gd name="T37" fmla="*/ 193 h 496"/>
                <a:gd name="T38" fmla="*/ 185 h 496"/>
                <a:gd name="T39" fmla="*/ 177 h 496"/>
                <a:gd name="T40" fmla="*/ 169 h 496"/>
                <a:gd name="T41" fmla="*/ 161 h 496"/>
                <a:gd name="T42" fmla="*/ 153 h 496"/>
                <a:gd name="T43" fmla="*/ 145 h 496"/>
                <a:gd name="T44" fmla="*/ 137 h 496"/>
                <a:gd name="T45" fmla="*/ 129 h 496"/>
                <a:gd name="T46" fmla="*/ 121 h 496"/>
                <a:gd name="T47" fmla="*/ 113 h 496"/>
                <a:gd name="T48" fmla="*/ 105 h 496"/>
                <a:gd name="T49" fmla="*/ 97 h 496"/>
                <a:gd name="T50" fmla="*/ 89 h 496"/>
                <a:gd name="T51" fmla="*/ 81 h 496"/>
                <a:gd name="T52" fmla="*/ 73 h 496"/>
                <a:gd name="T53" fmla="*/ 65 h 496"/>
                <a:gd name="T54" fmla="*/ 57 h 496"/>
                <a:gd name="T55" fmla="*/ 49 h 496"/>
                <a:gd name="T56" fmla="*/ 41 h 496"/>
                <a:gd name="T57" fmla="*/ 33 h 496"/>
                <a:gd name="T58" fmla="*/ 25 h 496"/>
                <a:gd name="T59" fmla="*/ 17 h 496"/>
                <a:gd name="T60" fmla="*/ 9 h 496"/>
                <a:gd name="T61" fmla="*/ 1 h 4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  <a:cxn ang="0">
                  <a:pos x="0" y="T55"/>
                </a:cxn>
                <a:cxn ang="0">
                  <a:pos x="0" y="T56"/>
                </a:cxn>
                <a:cxn ang="0">
                  <a:pos x="0" y="T57"/>
                </a:cxn>
                <a:cxn ang="0">
                  <a:pos x="0" y="T58"/>
                </a:cxn>
                <a:cxn ang="0">
                  <a:pos x="0" y="T59"/>
                </a:cxn>
                <a:cxn ang="0">
                  <a:pos x="0" y="T60"/>
                </a:cxn>
                <a:cxn ang="0">
                  <a:pos x="0" y="T61"/>
                </a:cxn>
              </a:cxnLst>
              <a:rect l="0" t="0" r="r" b="b"/>
              <a:pathLst>
                <a:path h="496">
                  <a:moveTo>
                    <a:pt x="0" y="493"/>
                  </a:moveTo>
                  <a:lnTo>
                    <a:pt x="0" y="492"/>
                  </a:lnTo>
                  <a:moveTo>
                    <a:pt x="0" y="489"/>
                  </a:moveTo>
                  <a:lnTo>
                    <a:pt x="0" y="488"/>
                  </a:lnTo>
                  <a:moveTo>
                    <a:pt x="0" y="485"/>
                  </a:moveTo>
                  <a:lnTo>
                    <a:pt x="0" y="484"/>
                  </a:lnTo>
                  <a:moveTo>
                    <a:pt x="0" y="481"/>
                  </a:moveTo>
                  <a:lnTo>
                    <a:pt x="0" y="480"/>
                  </a:lnTo>
                  <a:moveTo>
                    <a:pt x="0" y="477"/>
                  </a:moveTo>
                  <a:lnTo>
                    <a:pt x="0" y="476"/>
                  </a:lnTo>
                  <a:moveTo>
                    <a:pt x="0" y="473"/>
                  </a:moveTo>
                  <a:lnTo>
                    <a:pt x="0" y="472"/>
                  </a:lnTo>
                  <a:moveTo>
                    <a:pt x="0" y="469"/>
                  </a:moveTo>
                  <a:lnTo>
                    <a:pt x="0" y="468"/>
                  </a:lnTo>
                  <a:moveTo>
                    <a:pt x="0" y="465"/>
                  </a:moveTo>
                  <a:lnTo>
                    <a:pt x="0" y="464"/>
                  </a:lnTo>
                  <a:moveTo>
                    <a:pt x="0" y="461"/>
                  </a:moveTo>
                  <a:lnTo>
                    <a:pt x="0" y="460"/>
                  </a:lnTo>
                  <a:moveTo>
                    <a:pt x="0" y="457"/>
                  </a:moveTo>
                  <a:lnTo>
                    <a:pt x="0" y="456"/>
                  </a:lnTo>
                  <a:moveTo>
                    <a:pt x="0" y="453"/>
                  </a:moveTo>
                  <a:lnTo>
                    <a:pt x="0" y="452"/>
                  </a:lnTo>
                  <a:moveTo>
                    <a:pt x="0" y="449"/>
                  </a:moveTo>
                  <a:lnTo>
                    <a:pt x="0" y="448"/>
                  </a:lnTo>
                  <a:moveTo>
                    <a:pt x="0" y="445"/>
                  </a:moveTo>
                  <a:lnTo>
                    <a:pt x="0" y="444"/>
                  </a:lnTo>
                  <a:moveTo>
                    <a:pt x="0" y="441"/>
                  </a:moveTo>
                  <a:lnTo>
                    <a:pt x="0" y="440"/>
                  </a:lnTo>
                  <a:moveTo>
                    <a:pt x="0" y="437"/>
                  </a:moveTo>
                  <a:lnTo>
                    <a:pt x="0" y="436"/>
                  </a:lnTo>
                  <a:moveTo>
                    <a:pt x="0" y="433"/>
                  </a:moveTo>
                  <a:lnTo>
                    <a:pt x="0" y="432"/>
                  </a:lnTo>
                  <a:moveTo>
                    <a:pt x="0" y="429"/>
                  </a:moveTo>
                  <a:lnTo>
                    <a:pt x="0" y="428"/>
                  </a:lnTo>
                  <a:moveTo>
                    <a:pt x="0" y="425"/>
                  </a:moveTo>
                  <a:lnTo>
                    <a:pt x="0" y="424"/>
                  </a:lnTo>
                  <a:moveTo>
                    <a:pt x="0" y="421"/>
                  </a:moveTo>
                  <a:lnTo>
                    <a:pt x="0" y="420"/>
                  </a:lnTo>
                  <a:moveTo>
                    <a:pt x="0" y="417"/>
                  </a:moveTo>
                  <a:lnTo>
                    <a:pt x="0" y="416"/>
                  </a:lnTo>
                  <a:moveTo>
                    <a:pt x="0" y="413"/>
                  </a:moveTo>
                  <a:lnTo>
                    <a:pt x="0" y="412"/>
                  </a:lnTo>
                  <a:moveTo>
                    <a:pt x="0" y="409"/>
                  </a:moveTo>
                  <a:lnTo>
                    <a:pt x="0" y="408"/>
                  </a:lnTo>
                  <a:moveTo>
                    <a:pt x="0" y="405"/>
                  </a:moveTo>
                  <a:lnTo>
                    <a:pt x="0" y="404"/>
                  </a:lnTo>
                  <a:moveTo>
                    <a:pt x="0" y="401"/>
                  </a:moveTo>
                  <a:lnTo>
                    <a:pt x="0" y="400"/>
                  </a:lnTo>
                  <a:moveTo>
                    <a:pt x="0" y="397"/>
                  </a:moveTo>
                  <a:lnTo>
                    <a:pt x="0" y="396"/>
                  </a:lnTo>
                  <a:moveTo>
                    <a:pt x="0" y="393"/>
                  </a:moveTo>
                  <a:lnTo>
                    <a:pt x="0" y="392"/>
                  </a:lnTo>
                  <a:moveTo>
                    <a:pt x="0" y="389"/>
                  </a:moveTo>
                  <a:lnTo>
                    <a:pt x="0" y="388"/>
                  </a:lnTo>
                  <a:moveTo>
                    <a:pt x="0" y="385"/>
                  </a:moveTo>
                  <a:lnTo>
                    <a:pt x="0" y="384"/>
                  </a:lnTo>
                  <a:moveTo>
                    <a:pt x="0" y="381"/>
                  </a:moveTo>
                  <a:lnTo>
                    <a:pt x="0" y="380"/>
                  </a:lnTo>
                  <a:moveTo>
                    <a:pt x="0" y="377"/>
                  </a:moveTo>
                  <a:lnTo>
                    <a:pt x="0" y="376"/>
                  </a:lnTo>
                  <a:moveTo>
                    <a:pt x="0" y="373"/>
                  </a:moveTo>
                  <a:lnTo>
                    <a:pt x="0" y="372"/>
                  </a:lnTo>
                  <a:moveTo>
                    <a:pt x="0" y="369"/>
                  </a:moveTo>
                  <a:lnTo>
                    <a:pt x="0" y="368"/>
                  </a:lnTo>
                  <a:moveTo>
                    <a:pt x="0" y="365"/>
                  </a:moveTo>
                  <a:lnTo>
                    <a:pt x="0" y="364"/>
                  </a:lnTo>
                  <a:moveTo>
                    <a:pt x="0" y="361"/>
                  </a:moveTo>
                  <a:lnTo>
                    <a:pt x="0" y="360"/>
                  </a:lnTo>
                  <a:moveTo>
                    <a:pt x="0" y="357"/>
                  </a:moveTo>
                  <a:lnTo>
                    <a:pt x="0" y="356"/>
                  </a:lnTo>
                  <a:moveTo>
                    <a:pt x="0" y="353"/>
                  </a:moveTo>
                  <a:lnTo>
                    <a:pt x="0" y="352"/>
                  </a:lnTo>
                  <a:moveTo>
                    <a:pt x="0" y="349"/>
                  </a:moveTo>
                  <a:lnTo>
                    <a:pt x="0" y="348"/>
                  </a:lnTo>
                  <a:moveTo>
                    <a:pt x="0" y="345"/>
                  </a:moveTo>
                  <a:lnTo>
                    <a:pt x="0" y="344"/>
                  </a:lnTo>
                  <a:moveTo>
                    <a:pt x="0" y="341"/>
                  </a:moveTo>
                  <a:lnTo>
                    <a:pt x="0" y="340"/>
                  </a:lnTo>
                  <a:moveTo>
                    <a:pt x="0" y="337"/>
                  </a:moveTo>
                  <a:lnTo>
                    <a:pt x="0" y="336"/>
                  </a:lnTo>
                  <a:moveTo>
                    <a:pt x="0" y="333"/>
                  </a:moveTo>
                  <a:lnTo>
                    <a:pt x="0" y="332"/>
                  </a:lnTo>
                  <a:moveTo>
                    <a:pt x="0" y="329"/>
                  </a:moveTo>
                  <a:lnTo>
                    <a:pt x="0" y="328"/>
                  </a:lnTo>
                  <a:moveTo>
                    <a:pt x="0" y="325"/>
                  </a:moveTo>
                  <a:lnTo>
                    <a:pt x="0" y="324"/>
                  </a:lnTo>
                  <a:moveTo>
                    <a:pt x="0" y="321"/>
                  </a:moveTo>
                  <a:lnTo>
                    <a:pt x="0" y="320"/>
                  </a:lnTo>
                  <a:moveTo>
                    <a:pt x="0" y="317"/>
                  </a:moveTo>
                  <a:lnTo>
                    <a:pt x="0" y="316"/>
                  </a:lnTo>
                  <a:moveTo>
                    <a:pt x="0" y="313"/>
                  </a:moveTo>
                  <a:lnTo>
                    <a:pt x="0" y="312"/>
                  </a:lnTo>
                  <a:moveTo>
                    <a:pt x="0" y="309"/>
                  </a:moveTo>
                  <a:lnTo>
                    <a:pt x="0" y="308"/>
                  </a:lnTo>
                  <a:moveTo>
                    <a:pt x="0" y="305"/>
                  </a:moveTo>
                  <a:lnTo>
                    <a:pt x="0" y="304"/>
                  </a:lnTo>
                  <a:moveTo>
                    <a:pt x="0" y="301"/>
                  </a:moveTo>
                  <a:lnTo>
                    <a:pt x="0" y="300"/>
                  </a:lnTo>
                  <a:moveTo>
                    <a:pt x="0" y="297"/>
                  </a:moveTo>
                  <a:lnTo>
                    <a:pt x="0" y="296"/>
                  </a:lnTo>
                  <a:moveTo>
                    <a:pt x="0" y="293"/>
                  </a:moveTo>
                  <a:lnTo>
                    <a:pt x="0" y="292"/>
                  </a:lnTo>
                  <a:moveTo>
                    <a:pt x="0" y="289"/>
                  </a:moveTo>
                  <a:lnTo>
                    <a:pt x="0" y="288"/>
                  </a:lnTo>
                  <a:moveTo>
                    <a:pt x="0" y="285"/>
                  </a:moveTo>
                  <a:lnTo>
                    <a:pt x="0" y="284"/>
                  </a:lnTo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" name="Freeform 183">
              <a:extLst>
                <a:ext uri="{FF2B5EF4-FFF2-40B4-BE49-F238E27FC236}">
                  <a16:creationId xmlns:a16="http://schemas.microsoft.com/office/drawing/2014/main" id="{CFA4008D-95D3-EAD4-4947-49B01FB185C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91" y="5971"/>
              <a:ext cx="24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" name="Freeform 184">
              <a:extLst>
                <a:ext uri="{FF2B5EF4-FFF2-40B4-BE49-F238E27FC236}">
                  <a16:creationId xmlns:a16="http://schemas.microsoft.com/office/drawing/2014/main" id="{82BDC13A-C398-E58C-1CB9-407211DFDF7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91" y="5565"/>
              <a:ext cx="24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" name="Freeform 185">
              <a:extLst>
                <a:ext uri="{FF2B5EF4-FFF2-40B4-BE49-F238E27FC236}">
                  <a16:creationId xmlns:a16="http://schemas.microsoft.com/office/drawing/2014/main" id="{5412C778-6973-E34B-4664-B1C68E3EDDA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91" y="5160"/>
              <a:ext cx="24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" name="Freeform 186">
              <a:extLst>
                <a:ext uri="{FF2B5EF4-FFF2-40B4-BE49-F238E27FC236}">
                  <a16:creationId xmlns:a16="http://schemas.microsoft.com/office/drawing/2014/main" id="{394AA2FA-B1C5-D906-61E2-26B5A08FE46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91" y="4754"/>
              <a:ext cx="24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3" name="Freeform 187">
              <a:extLst>
                <a:ext uri="{FF2B5EF4-FFF2-40B4-BE49-F238E27FC236}">
                  <a16:creationId xmlns:a16="http://schemas.microsoft.com/office/drawing/2014/main" id="{361C5EAD-DD2E-53A2-CD59-E15D06343C2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91" y="4353"/>
              <a:ext cx="24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" name="Freeform 188">
              <a:extLst>
                <a:ext uri="{FF2B5EF4-FFF2-40B4-BE49-F238E27FC236}">
                  <a16:creationId xmlns:a16="http://schemas.microsoft.com/office/drawing/2014/main" id="{6E7E52B7-58F0-496F-66BB-6336F8F0976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91" y="3947"/>
              <a:ext cx="244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674993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11</TotalTime>
  <Words>115</Words>
  <Application>Microsoft Office PowerPoint</Application>
  <PresentationFormat>A4 210 x 297 mm</PresentationFormat>
  <Paragraphs>6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川貴史</dc:creator>
  <cp:lastModifiedBy>Takashi Fujikawa</cp:lastModifiedBy>
  <cp:revision>13</cp:revision>
  <cp:lastPrinted>2024-08-09T05:41:05Z</cp:lastPrinted>
  <dcterms:created xsi:type="dcterms:W3CDTF">2024-05-22T04:00:38Z</dcterms:created>
  <dcterms:modified xsi:type="dcterms:W3CDTF">2025-02-21T02:15:16Z</dcterms:modified>
</cp:coreProperties>
</file>